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  <p:sldId id="259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044" y="-1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dson Adriano" userId="38e94374d22881a3" providerId="LiveId" clId="{EDD18980-3E45-4287-8560-24571ACEB754}"/>
    <pc:docChg chg="undo custSel addSld delSld modSld">
      <pc:chgData name="Edson Adriano" userId="38e94374d22881a3" providerId="LiveId" clId="{EDD18980-3E45-4287-8560-24571ACEB754}" dt="2024-03-03T19:34:04.956" v="1985" actId="20577"/>
      <pc:docMkLst>
        <pc:docMk/>
      </pc:docMkLst>
      <pc:sldChg chg="delSp modSp del mod">
        <pc:chgData name="Edson Adriano" userId="38e94374d22881a3" providerId="LiveId" clId="{EDD18980-3E45-4287-8560-24571ACEB754}" dt="2024-03-03T19:23:38.565" v="1910" actId="47"/>
        <pc:sldMkLst>
          <pc:docMk/>
          <pc:sldMk cId="98315632" sldId="256"/>
        </pc:sldMkLst>
        <pc:spChg chg="del">
          <ac:chgData name="Edson Adriano" userId="38e94374d22881a3" providerId="LiveId" clId="{EDD18980-3E45-4287-8560-24571ACEB754}" dt="2024-03-03T17:48:56.050" v="886" actId="478"/>
          <ac:spMkLst>
            <pc:docMk/>
            <pc:sldMk cId="98315632" sldId="256"/>
            <ac:spMk id="5" creationId="{89A143AD-CA22-F816-0DF9-0A715726C7E6}"/>
          </ac:spMkLst>
        </pc:spChg>
        <pc:spChg chg="del">
          <ac:chgData name="Edson Adriano" userId="38e94374d22881a3" providerId="LiveId" clId="{EDD18980-3E45-4287-8560-24571ACEB754}" dt="2024-03-03T17:48:56.050" v="886" actId="478"/>
          <ac:spMkLst>
            <pc:docMk/>
            <pc:sldMk cId="98315632" sldId="256"/>
            <ac:spMk id="6" creationId="{ECC21DF8-E699-8DAE-4A9B-6052641D6BD0}"/>
          </ac:spMkLst>
        </pc:spChg>
        <pc:spChg chg="del mod">
          <ac:chgData name="Edson Adriano" userId="38e94374d22881a3" providerId="LiveId" clId="{EDD18980-3E45-4287-8560-24571ACEB754}" dt="2024-03-03T19:23:10.743" v="1907" actId="478"/>
          <ac:spMkLst>
            <pc:docMk/>
            <pc:sldMk cId="98315632" sldId="256"/>
            <ac:spMk id="7" creationId="{A84EA66D-9C86-C260-EB68-E2F80F95CB3E}"/>
          </ac:spMkLst>
        </pc:spChg>
        <pc:spChg chg="del mod">
          <ac:chgData name="Edson Adriano" userId="38e94374d22881a3" providerId="LiveId" clId="{EDD18980-3E45-4287-8560-24571ACEB754}" dt="2024-03-03T19:23:35.404" v="1909" actId="478"/>
          <ac:spMkLst>
            <pc:docMk/>
            <pc:sldMk cId="98315632" sldId="256"/>
            <ac:spMk id="9" creationId="{77ED1076-A4D3-6A38-5EBC-01D084F1ACEF}"/>
          </ac:spMkLst>
        </pc:spChg>
      </pc:sldChg>
      <pc:sldChg chg="addSp delSp modSp new mod">
        <pc:chgData name="Edson Adriano" userId="38e94374d22881a3" providerId="LiveId" clId="{EDD18980-3E45-4287-8560-24571ACEB754}" dt="2024-03-03T19:22:15.328" v="1901" actId="20577"/>
        <pc:sldMkLst>
          <pc:docMk/>
          <pc:sldMk cId="2931561781" sldId="257"/>
        </pc:sldMkLst>
        <pc:spChg chg="del">
          <ac:chgData name="Edson Adriano" userId="38e94374d22881a3" providerId="LiveId" clId="{EDD18980-3E45-4287-8560-24571ACEB754}" dt="2024-03-01T16:04:56.377" v="1" actId="478"/>
          <ac:spMkLst>
            <pc:docMk/>
            <pc:sldMk cId="2931561781" sldId="257"/>
            <ac:spMk id="2" creationId="{EADB8B41-F252-BFCD-838F-5D83A07B2486}"/>
          </ac:spMkLst>
        </pc:spChg>
        <pc:spChg chg="del">
          <ac:chgData name="Edson Adriano" userId="38e94374d22881a3" providerId="LiveId" clId="{EDD18980-3E45-4287-8560-24571ACEB754}" dt="2024-03-01T16:04:56.377" v="1" actId="478"/>
          <ac:spMkLst>
            <pc:docMk/>
            <pc:sldMk cId="2931561781" sldId="257"/>
            <ac:spMk id="3" creationId="{B0610263-DED7-B41F-0E0A-3EC76031AED2}"/>
          </ac:spMkLst>
        </pc:spChg>
        <pc:spChg chg="add del mod">
          <ac:chgData name="Edson Adriano" userId="38e94374d22881a3" providerId="LiveId" clId="{EDD18980-3E45-4287-8560-24571ACEB754}" dt="2024-03-01T19:06:41.646" v="18" actId="478"/>
          <ac:spMkLst>
            <pc:docMk/>
            <pc:sldMk cId="2931561781" sldId="257"/>
            <ac:spMk id="6" creationId="{A9216CB7-0B37-A6BA-E56A-1FD298C57974}"/>
          </ac:spMkLst>
        </pc:spChg>
        <pc:spChg chg="add mod">
          <ac:chgData name="Edson Adriano" userId="38e94374d22881a3" providerId="LiveId" clId="{EDD18980-3E45-4287-8560-24571ACEB754}" dt="2024-03-03T19:22:15.328" v="1901" actId="20577"/>
          <ac:spMkLst>
            <pc:docMk/>
            <pc:sldMk cId="2931561781" sldId="257"/>
            <ac:spMk id="7" creationId="{D2C1EC59-229E-D5E3-B5A5-27B063CC3C44}"/>
          </ac:spMkLst>
        </pc:spChg>
        <pc:spChg chg="mod topLvl">
          <ac:chgData name="Edson Adriano" userId="38e94374d22881a3" providerId="LiveId" clId="{EDD18980-3E45-4287-8560-24571ACEB754}" dt="2024-03-03T17:53:01.829" v="936" actId="164"/>
          <ac:spMkLst>
            <pc:docMk/>
            <pc:sldMk cId="2931561781" sldId="257"/>
            <ac:spMk id="14" creationId="{5B224254-FBC1-D809-35F4-0FB33F8918BD}"/>
          </ac:spMkLst>
        </pc:spChg>
        <pc:spChg chg="mod topLvl">
          <ac:chgData name="Edson Adriano" userId="38e94374d22881a3" providerId="LiveId" clId="{EDD18980-3E45-4287-8560-24571ACEB754}" dt="2024-03-03T17:53:01.829" v="936" actId="164"/>
          <ac:spMkLst>
            <pc:docMk/>
            <pc:sldMk cId="2931561781" sldId="257"/>
            <ac:spMk id="15" creationId="{46C176E9-016A-A724-3CB9-1977DF2C9D4E}"/>
          </ac:spMkLst>
        </pc:spChg>
        <pc:spChg chg="mod topLvl">
          <ac:chgData name="Edson Adriano" userId="38e94374d22881a3" providerId="LiveId" clId="{EDD18980-3E45-4287-8560-24571ACEB754}" dt="2024-03-03T17:53:01.829" v="936" actId="164"/>
          <ac:spMkLst>
            <pc:docMk/>
            <pc:sldMk cId="2931561781" sldId="257"/>
            <ac:spMk id="16" creationId="{6BFB32C2-4408-10F6-20BA-2F1071F3B94A}"/>
          </ac:spMkLst>
        </pc:spChg>
        <pc:spChg chg="mod topLvl">
          <ac:chgData name="Edson Adriano" userId="38e94374d22881a3" providerId="LiveId" clId="{EDD18980-3E45-4287-8560-24571ACEB754}" dt="2024-03-03T17:53:28.223" v="938" actId="255"/>
          <ac:spMkLst>
            <pc:docMk/>
            <pc:sldMk cId="2931561781" sldId="257"/>
            <ac:spMk id="17" creationId="{87C1D66D-18C9-717F-0D43-B06BDBFB373C}"/>
          </ac:spMkLst>
        </pc:spChg>
        <pc:spChg chg="mod topLvl">
          <ac:chgData name="Edson Adriano" userId="38e94374d22881a3" providerId="LiveId" clId="{EDD18980-3E45-4287-8560-24571ACEB754}" dt="2024-03-03T17:53:28.223" v="938" actId="255"/>
          <ac:spMkLst>
            <pc:docMk/>
            <pc:sldMk cId="2931561781" sldId="257"/>
            <ac:spMk id="18" creationId="{1816BAEE-15C3-9B39-8857-CF1415A7C10A}"/>
          </ac:spMkLst>
        </pc:spChg>
        <pc:spChg chg="mod topLvl">
          <ac:chgData name="Edson Adriano" userId="38e94374d22881a3" providerId="LiveId" clId="{EDD18980-3E45-4287-8560-24571ACEB754}" dt="2024-03-03T17:53:28.223" v="938" actId="255"/>
          <ac:spMkLst>
            <pc:docMk/>
            <pc:sldMk cId="2931561781" sldId="257"/>
            <ac:spMk id="28" creationId="{4A2632C8-AECF-242D-62E0-659BF53BA181}"/>
          </ac:spMkLst>
        </pc:spChg>
        <pc:spChg chg="mod topLvl">
          <ac:chgData name="Edson Adriano" userId="38e94374d22881a3" providerId="LiveId" clId="{EDD18980-3E45-4287-8560-24571ACEB754}" dt="2024-03-03T17:53:28.223" v="938" actId="255"/>
          <ac:spMkLst>
            <pc:docMk/>
            <pc:sldMk cId="2931561781" sldId="257"/>
            <ac:spMk id="29" creationId="{C2DD064E-1062-3177-34CE-07BA9CEE1702}"/>
          </ac:spMkLst>
        </pc:spChg>
        <pc:spChg chg="mod topLvl">
          <ac:chgData name="Edson Adriano" userId="38e94374d22881a3" providerId="LiveId" clId="{EDD18980-3E45-4287-8560-24571ACEB754}" dt="2024-03-03T17:53:01.829" v="936" actId="164"/>
          <ac:spMkLst>
            <pc:docMk/>
            <pc:sldMk cId="2931561781" sldId="257"/>
            <ac:spMk id="30" creationId="{B89ED100-9EDC-13A7-C556-87FA41F4F139}"/>
          </ac:spMkLst>
        </pc:spChg>
        <pc:grpChg chg="add mod">
          <ac:chgData name="Edson Adriano" userId="38e94374d22881a3" providerId="LiveId" clId="{EDD18980-3E45-4287-8560-24571ACEB754}" dt="2024-03-03T17:53:01.829" v="936" actId="164"/>
          <ac:grpSpMkLst>
            <pc:docMk/>
            <pc:sldMk cId="2931561781" sldId="257"/>
            <ac:grpSpMk id="2" creationId="{76275AB1-1809-7743-6354-FB5BFA9EA1EF}"/>
          </ac:grpSpMkLst>
        </pc:grpChg>
        <pc:grpChg chg="add del mod">
          <ac:chgData name="Edson Adriano" userId="38e94374d22881a3" providerId="LiveId" clId="{EDD18980-3E45-4287-8560-24571ACEB754}" dt="2024-03-03T17:52:54.041" v="935" actId="165"/>
          <ac:grpSpMkLst>
            <pc:docMk/>
            <pc:sldMk cId="2931561781" sldId="257"/>
            <ac:grpSpMk id="31" creationId="{7C34640A-B5E1-6AF5-2DCB-BD5C71BAF438}"/>
          </ac:grpSpMkLst>
        </pc:grpChg>
        <pc:picChg chg="add del mod">
          <ac:chgData name="Edson Adriano" userId="38e94374d22881a3" providerId="LiveId" clId="{EDD18980-3E45-4287-8560-24571ACEB754}" dt="2024-03-01T19:06:41.646" v="18" actId="478"/>
          <ac:picMkLst>
            <pc:docMk/>
            <pc:sldMk cId="2931561781" sldId="257"/>
            <ac:picMk id="4" creationId="{A1EDAAFE-1B6C-9EA3-D091-766E1792478C}"/>
          </ac:picMkLst>
        </pc:picChg>
        <pc:picChg chg="mod topLvl">
          <ac:chgData name="Edson Adriano" userId="38e94374d22881a3" providerId="LiveId" clId="{EDD18980-3E45-4287-8560-24571ACEB754}" dt="2024-03-03T17:53:01.829" v="936" actId="164"/>
          <ac:picMkLst>
            <pc:docMk/>
            <pc:sldMk cId="2931561781" sldId="257"/>
            <ac:picMk id="8" creationId="{5D32BCDC-A102-28BE-36B1-02F6E0F1CB0E}"/>
          </ac:picMkLst>
        </pc:picChg>
        <pc:picChg chg="mod topLvl">
          <ac:chgData name="Edson Adriano" userId="38e94374d22881a3" providerId="LiveId" clId="{EDD18980-3E45-4287-8560-24571ACEB754}" dt="2024-03-03T17:53:01.829" v="936" actId="164"/>
          <ac:picMkLst>
            <pc:docMk/>
            <pc:sldMk cId="2931561781" sldId="257"/>
            <ac:picMk id="9" creationId="{A02627A0-1AE4-F817-BCEE-8135D5EC2E09}"/>
          </ac:picMkLst>
        </pc:picChg>
        <pc:picChg chg="mod topLvl">
          <ac:chgData name="Edson Adriano" userId="38e94374d22881a3" providerId="LiveId" clId="{EDD18980-3E45-4287-8560-24571ACEB754}" dt="2024-03-03T17:53:01.829" v="936" actId="164"/>
          <ac:picMkLst>
            <pc:docMk/>
            <pc:sldMk cId="2931561781" sldId="257"/>
            <ac:picMk id="12" creationId="{067CDFD7-3047-BFDF-FF02-809639D9A85D}"/>
          </ac:picMkLst>
        </pc:picChg>
        <pc:cxnChg chg="mod topLvl">
          <ac:chgData name="Edson Adriano" userId="38e94374d22881a3" providerId="LiveId" clId="{EDD18980-3E45-4287-8560-24571ACEB754}" dt="2024-03-03T17:53:01.829" v="936" actId="164"/>
          <ac:cxnSpMkLst>
            <pc:docMk/>
            <pc:sldMk cId="2931561781" sldId="257"/>
            <ac:cxnSpMk id="22" creationId="{F7320E20-1D6F-7ED9-B7B7-ED2C4A6133A9}"/>
          </ac:cxnSpMkLst>
        </pc:cxnChg>
        <pc:cxnChg chg="mod topLvl">
          <ac:chgData name="Edson Adriano" userId="38e94374d22881a3" providerId="LiveId" clId="{EDD18980-3E45-4287-8560-24571ACEB754}" dt="2024-03-03T17:53:01.829" v="936" actId="164"/>
          <ac:cxnSpMkLst>
            <pc:docMk/>
            <pc:sldMk cId="2931561781" sldId="257"/>
            <ac:cxnSpMk id="23" creationId="{266C0995-7CA4-C113-DF72-6899F5637E31}"/>
          </ac:cxnSpMkLst>
        </pc:cxnChg>
        <pc:cxnChg chg="mod topLvl">
          <ac:chgData name="Edson Adriano" userId="38e94374d22881a3" providerId="LiveId" clId="{EDD18980-3E45-4287-8560-24571ACEB754}" dt="2024-03-03T17:53:01.829" v="936" actId="164"/>
          <ac:cxnSpMkLst>
            <pc:docMk/>
            <pc:sldMk cId="2931561781" sldId="257"/>
            <ac:cxnSpMk id="25" creationId="{C3923A0B-7D0E-B2FD-CAEE-8712FF9E1B10}"/>
          </ac:cxnSpMkLst>
        </pc:cxnChg>
      </pc:sldChg>
      <pc:sldChg chg="addSp delSp modSp new mod">
        <pc:chgData name="Edson Adriano" userId="38e94374d22881a3" providerId="LiveId" clId="{EDD18980-3E45-4287-8560-24571ACEB754}" dt="2024-03-03T19:22:43.031" v="1905" actId="6549"/>
        <pc:sldMkLst>
          <pc:docMk/>
          <pc:sldMk cId="2308866928" sldId="258"/>
        </pc:sldMkLst>
        <pc:spChg chg="del">
          <ac:chgData name="Edson Adriano" userId="38e94374d22881a3" providerId="LiveId" clId="{EDD18980-3E45-4287-8560-24571ACEB754}" dt="2024-03-03T16:19:26.030" v="21" actId="478"/>
          <ac:spMkLst>
            <pc:docMk/>
            <pc:sldMk cId="2308866928" sldId="258"/>
            <ac:spMk id="2" creationId="{BFD7F999-1720-1F5E-7B3C-BBC9184F57D2}"/>
          </ac:spMkLst>
        </pc:spChg>
        <pc:spChg chg="del">
          <ac:chgData name="Edson Adriano" userId="38e94374d22881a3" providerId="LiveId" clId="{EDD18980-3E45-4287-8560-24571ACEB754}" dt="2024-03-03T16:19:26.030" v="21" actId="478"/>
          <ac:spMkLst>
            <pc:docMk/>
            <pc:sldMk cId="2308866928" sldId="258"/>
            <ac:spMk id="3" creationId="{71319E29-2C2E-6D88-72E0-E0AB761E52BF}"/>
          </ac:spMkLst>
        </pc:spChg>
        <pc:spChg chg="add del mod">
          <ac:chgData name="Edson Adriano" userId="38e94374d22881a3" providerId="LiveId" clId="{EDD18980-3E45-4287-8560-24571ACEB754}" dt="2024-03-03T17:48:26.785" v="826" actId="478"/>
          <ac:spMkLst>
            <pc:docMk/>
            <pc:sldMk cId="2308866928" sldId="258"/>
            <ac:spMk id="5" creationId="{11E8B008-6E60-62FB-7EC6-F12627018F66}"/>
          </ac:spMkLst>
        </pc:spChg>
        <pc:spChg chg="add mod">
          <ac:chgData name="Edson Adriano" userId="38e94374d22881a3" providerId="LiveId" clId="{EDD18980-3E45-4287-8560-24571ACEB754}" dt="2024-03-03T19:22:43.031" v="1905" actId="6549"/>
          <ac:spMkLst>
            <pc:docMk/>
            <pc:sldMk cId="2308866928" sldId="258"/>
            <ac:spMk id="7" creationId="{7C6E342A-477D-4E16-A147-711E07AD639E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8" creationId="{A703A7F4-CEDF-E711-9781-5924632DE79A}"/>
          </ac:spMkLst>
        </pc:spChg>
        <pc:spChg chg="add del mod topLvl">
          <ac:chgData name="Edson Adriano" userId="38e94374d22881a3" providerId="LiveId" clId="{EDD18980-3E45-4287-8560-24571ACEB754}" dt="2024-03-03T17:31:09.497" v="453" actId="478"/>
          <ac:spMkLst>
            <pc:docMk/>
            <pc:sldMk cId="2308866928" sldId="258"/>
            <ac:spMk id="11" creationId="{BF3BA972-879E-CCCF-A7D8-4118000DDCA4}"/>
          </ac:spMkLst>
        </pc:spChg>
        <pc:spChg chg="add del mod">
          <ac:chgData name="Edson Adriano" userId="38e94374d22881a3" providerId="LiveId" clId="{EDD18980-3E45-4287-8560-24571ACEB754}" dt="2024-03-03T17:31:30.804" v="454" actId="478"/>
          <ac:spMkLst>
            <pc:docMk/>
            <pc:sldMk cId="2308866928" sldId="258"/>
            <ac:spMk id="14" creationId="{C915ED09-07D7-9571-4220-4A5BD9DEB1A0}"/>
          </ac:spMkLst>
        </pc:spChg>
        <pc:spChg chg="add del mod">
          <ac:chgData name="Edson Adriano" userId="38e94374d22881a3" providerId="LiveId" clId="{EDD18980-3E45-4287-8560-24571ACEB754}" dt="2024-03-03T17:31:07.684" v="452" actId="478"/>
          <ac:spMkLst>
            <pc:docMk/>
            <pc:sldMk cId="2308866928" sldId="258"/>
            <ac:spMk id="18" creationId="{B5D421CB-95AA-2C41-F2A3-75DFC6E05D2C}"/>
          </ac:spMkLst>
        </pc:spChg>
        <pc:spChg chg="add del mod">
          <ac:chgData name="Edson Adriano" userId="38e94374d22881a3" providerId="LiveId" clId="{EDD18980-3E45-4287-8560-24571ACEB754}" dt="2024-03-03T17:31:04.364" v="451" actId="478"/>
          <ac:spMkLst>
            <pc:docMk/>
            <pc:sldMk cId="2308866928" sldId="258"/>
            <ac:spMk id="21" creationId="{861766F1-B07B-2749-BB72-FC9E46C4B2D7}"/>
          </ac:spMkLst>
        </pc:spChg>
        <pc:spChg chg="add del mod">
          <ac:chgData name="Edson Adriano" userId="38e94374d22881a3" providerId="LiveId" clId="{EDD18980-3E45-4287-8560-24571ACEB754}" dt="2024-03-03T17:30:59.820" v="449" actId="478"/>
          <ac:spMkLst>
            <pc:docMk/>
            <pc:sldMk cId="2308866928" sldId="258"/>
            <ac:spMk id="27" creationId="{9B75195C-915A-FDBA-BD41-A013F928AAD4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28" creationId="{B0A0316E-9723-0A09-99AC-61369B7C8573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29" creationId="{9D309294-4900-FD79-518D-3185723D56F9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30" creationId="{3F2AA932-0311-FA85-EF07-69737644CA4D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31" creationId="{02B5FC4C-78B3-2755-FE0E-82FB4B080BB4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32" creationId="{7815C907-34D8-D709-4389-4231A98A5602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33" creationId="{BF32E3BF-6F7E-B94E-6747-4AFF112A71DB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34" creationId="{B69959A4-B76D-43B9-CDC5-EA2A2F883ED9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35" creationId="{3584D202-BC1D-048E-DEEC-539BD7E292D0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36" creationId="{306D67DD-3298-DB27-C16D-068D44AA7A55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37" creationId="{7708A017-08B2-BAF6-F670-3A321063DDF4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38" creationId="{4A226493-7DB5-90ED-6A1D-18A9FA1ED73D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54" creationId="{6B5668CF-1B4E-4058-402D-396F53443A72}"/>
          </ac:spMkLst>
        </pc:spChg>
        <pc:spChg chg="add mod">
          <ac:chgData name="Edson Adriano" userId="38e94374d22881a3" providerId="LiveId" clId="{EDD18980-3E45-4287-8560-24571ACEB754}" dt="2024-03-03T17:47:40.465" v="820" actId="164"/>
          <ac:spMkLst>
            <pc:docMk/>
            <pc:sldMk cId="2308866928" sldId="258"/>
            <ac:spMk id="55" creationId="{A1B4253D-BFEA-C479-1C61-35E999D1F875}"/>
          </ac:spMkLst>
        </pc:spChg>
        <pc:grpChg chg="add mod">
          <ac:chgData name="Edson Adriano" userId="38e94374d22881a3" providerId="LiveId" clId="{EDD18980-3E45-4287-8560-24571ACEB754}" dt="2024-03-03T17:48:47.195" v="885" actId="1035"/>
          <ac:grpSpMkLst>
            <pc:docMk/>
            <pc:sldMk cId="2308866928" sldId="258"/>
            <ac:grpSpMk id="2" creationId="{06671DF1-B8B5-4DAD-A3DF-92686A13A72C}"/>
          </ac:grpSpMkLst>
        </pc:grpChg>
        <pc:grpChg chg="add del mod">
          <ac:chgData name="Edson Adriano" userId="38e94374d22881a3" providerId="LiveId" clId="{EDD18980-3E45-4287-8560-24571ACEB754}" dt="2024-03-03T17:31:09.497" v="453" actId="478"/>
          <ac:grpSpMkLst>
            <pc:docMk/>
            <pc:sldMk cId="2308866928" sldId="258"/>
            <ac:grpSpMk id="17" creationId="{0C915D76-74AF-5A93-E187-CB50ADA77474}"/>
          </ac:grpSpMkLst>
        </pc:grpChg>
        <pc:picChg chg="add mod">
          <ac:chgData name="Edson Adriano" userId="38e94374d22881a3" providerId="LiveId" clId="{EDD18980-3E45-4287-8560-24571ACEB754}" dt="2024-03-03T17:47:40.465" v="820" actId="164"/>
          <ac:picMkLst>
            <pc:docMk/>
            <pc:sldMk cId="2308866928" sldId="258"/>
            <ac:picMk id="6" creationId="{8C49908F-9BF1-AA74-76C7-F3844CEFCCF8}"/>
          </ac:picMkLst>
        </pc:picChg>
        <pc:picChg chg="add mod topLvl">
          <ac:chgData name="Edson Adriano" userId="38e94374d22881a3" providerId="LiveId" clId="{EDD18980-3E45-4287-8560-24571ACEB754}" dt="2024-03-03T17:47:40.465" v="820" actId="164"/>
          <ac:picMkLst>
            <pc:docMk/>
            <pc:sldMk cId="2308866928" sldId="258"/>
            <ac:picMk id="10" creationId="{48CB6757-8C3D-7521-9D4F-E89B3A542660}"/>
          </ac:picMkLst>
        </pc:picChg>
        <pc:picChg chg="add mod">
          <ac:chgData name="Edson Adriano" userId="38e94374d22881a3" providerId="LiveId" clId="{EDD18980-3E45-4287-8560-24571ACEB754}" dt="2024-03-03T17:47:40.465" v="820" actId="164"/>
          <ac:picMkLst>
            <pc:docMk/>
            <pc:sldMk cId="2308866928" sldId="258"/>
            <ac:picMk id="13" creationId="{9997C341-8DF1-5E00-4591-128DACA394C5}"/>
          </ac:picMkLst>
        </pc:picChg>
        <pc:picChg chg="add mod">
          <ac:chgData name="Edson Adriano" userId="38e94374d22881a3" providerId="LiveId" clId="{EDD18980-3E45-4287-8560-24571ACEB754}" dt="2024-03-03T17:47:54.158" v="822" actId="1038"/>
          <ac:picMkLst>
            <pc:docMk/>
            <pc:sldMk cId="2308866928" sldId="258"/>
            <ac:picMk id="16" creationId="{D2BE7415-F44B-6048-C146-FBD4D88383A6}"/>
          </ac:picMkLst>
        </pc:picChg>
        <pc:picChg chg="add del mod">
          <ac:chgData name="Edson Adriano" userId="38e94374d22881a3" providerId="LiveId" clId="{EDD18980-3E45-4287-8560-24571ACEB754}" dt="2024-03-03T17:09:09.759" v="138" actId="478"/>
          <ac:picMkLst>
            <pc:docMk/>
            <pc:sldMk cId="2308866928" sldId="258"/>
            <ac:picMk id="20" creationId="{C5C133A0-E570-5CB6-5B46-025A8226DE51}"/>
          </ac:picMkLst>
        </pc:picChg>
        <pc:picChg chg="add mod ord">
          <ac:chgData name="Edson Adriano" userId="38e94374d22881a3" providerId="LiveId" clId="{EDD18980-3E45-4287-8560-24571ACEB754}" dt="2024-03-03T17:47:40.465" v="820" actId="164"/>
          <ac:picMkLst>
            <pc:docMk/>
            <pc:sldMk cId="2308866928" sldId="258"/>
            <ac:picMk id="22" creationId="{57A741FA-81F6-7D01-DF75-76BA6EFEBF92}"/>
          </ac:picMkLst>
        </pc:picChg>
        <pc:picChg chg="add del mod">
          <ac:chgData name="Edson Adriano" userId="38e94374d22881a3" providerId="LiveId" clId="{EDD18980-3E45-4287-8560-24571ACEB754}" dt="2024-03-03T17:15:48.830" v="154" actId="478"/>
          <ac:picMkLst>
            <pc:docMk/>
            <pc:sldMk cId="2308866928" sldId="258"/>
            <ac:picMk id="24" creationId="{C69F27D2-B544-16DE-72AF-9D468A897484}"/>
          </ac:picMkLst>
        </pc:picChg>
        <pc:picChg chg="add mod">
          <ac:chgData name="Edson Adriano" userId="38e94374d22881a3" providerId="LiveId" clId="{EDD18980-3E45-4287-8560-24571ACEB754}" dt="2024-03-03T17:47:40.465" v="820" actId="164"/>
          <ac:picMkLst>
            <pc:docMk/>
            <pc:sldMk cId="2308866928" sldId="258"/>
            <ac:picMk id="26" creationId="{46298C8D-33E6-C0BA-D4BD-B173D83E6DB2}"/>
          </ac:picMkLst>
        </pc:picChg>
        <pc:cxnChg chg="add mod">
          <ac:chgData name="Edson Adriano" userId="38e94374d22881a3" providerId="LiveId" clId="{EDD18980-3E45-4287-8560-24571ACEB754}" dt="2024-03-03T17:47:40.465" v="820" actId="164"/>
          <ac:cxnSpMkLst>
            <pc:docMk/>
            <pc:sldMk cId="2308866928" sldId="258"/>
            <ac:cxnSpMk id="40" creationId="{3AA06E24-62F7-AE48-9CB6-AEE6AA9546A1}"/>
          </ac:cxnSpMkLst>
        </pc:cxnChg>
        <pc:cxnChg chg="add mod">
          <ac:chgData name="Edson Adriano" userId="38e94374d22881a3" providerId="LiveId" clId="{EDD18980-3E45-4287-8560-24571ACEB754}" dt="2024-03-03T17:47:40.465" v="820" actId="164"/>
          <ac:cxnSpMkLst>
            <pc:docMk/>
            <pc:sldMk cId="2308866928" sldId="258"/>
            <ac:cxnSpMk id="42" creationId="{BA0FAAEE-64FB-0D21-7E28-E58C9650D019}"/>
          </ac:cxnSpMkLst>
        </pc:cxnChg>
        <pc:cxnChg chg="add mod">
          <ac:chgData name="Edson Adriano" userId="38e94374d22881a3" providerId="LiveId" clId="{EDD18980-3E45-4287-8560-24571ACEB754}" dt="2024-03-03T17:35:30.883" v="502"/>
          <ac:cxnSpMkLst>
            <pc:docMk/>
            <pc:sldMk cId="2308866928" sldId="258"/>
            <ac:cxnSpMk id="44" creationId="{584CF8C3-FB39-C15D-4453-6E2049DD73E6}"/>
          </ac:cxnSpMkLst>
        </pc:cxnChg>
        <pc:cxnChg chg="add mod">
          <ac:chgData name="Edson Adriano" userId="38e94374d22881a3" providerId="LiveId" clId="{EDD18980-3E45-4287-8560-24571ACEB754}" dt="2024-03-03T17:47:40.465" v="820" actId="164"/>
          <ac:cxnSpMkLst>
            <pc:docMk/>
            <pc:sldMk cId="2308866928" sldId="258"/>
            <ac:cxnSpMk id="45" creationId="{FCDD7950-2A3F-03BC-438F-D0C44720F540}"/>
          </ac:cxnSpMkLst>
        </pc:cxnChg>
        <pc:cxnChg chg="add mod">
          <ac:chgData name="Edson Adriano" userId="38e94374d22881a3" providerId="LiveId" clId="{EDD18980-3E45-4287-8560-24571ACEB754}" dt="2024-03-03T17:47:40.465" v="820" actId="164"/>
          <ac:cxnSpMkLst>
            <pc:docMk/>
            <pc:sldMk cId="2308866928" sldId="258"/>
            <ac:cxnSpMk id="46" creationId="{10A87265-BFFF-5D7E-2299-E0C5D5ACFA25}"/>
          </ac:cxnSpMkLst>
        </pc:cxnChg>
        <pc:cxnChg chg="add mod">
          <ac:chgData name="Edson Adriano" userId="38e94374d22881a3" providerId="LiveId" clId="{EDD18980-3E45-4287-8560-24571ACEB754}" dt="2024-03-03T17:47:40.465" v="820" actId="164"/>
          <ac:cxnSpMkLst>
            <pc:docMk/>
            <pc:sldMk cId="2308866928" sldId="258"/>
            <ac:cxnSpMk id="48" creationId="{B8122649-CACE-31FE-B7D0-5214DF4BFB7E}"/>
          </ac:cxnSpMkLst>
        </pc:cxnChg>
        <pc:cxnChg chg="add mod">
          <ac:chgData name="Edson Adriano" userId="38e94374d22881a3" providerId="LiveId" clId="{EDD18980-3E45-4287-8560-24571ACEB754}" dt="2024-03-03T17:47:40.465" v="820" actId="164"/>
          <ac:cxnSpMkLst>
            <pc:docMk/>
            <pc:sldMk cId="2308866928" sldId="258"/>
            <ac:cxnSpMk id="49" creationId="{AD920821-2D9C-DDC4-3392-9D8FF4EEBEE5}"/>
          </ac:cxnSpMkLst>
        </pc:cxnChg>
        <pc:cxnChg chg="add mod">
          <ac:chgData name="Edson Adriano" userId="38e94374d22881a3" providerId="LiveId" clId="{EDD18980-3E45-4287-8560-24571ACEB754}" dt="2024-03-03T17:47:40.465" v="820" actId="164"/>
          <ac:cxnSpMkLst>
            <pc:docMk/>
            <pc:sldMk cId="2308866928" sldId="258"/>
            <ac:cxnSpMk id="52" creationId="{1770CD07-7715-2F78-EEED-EC47CEC17BCD}"/>
          </ac:cxnSpMkLst>
        </pc:cxnChg>
        <pc:cxnChg chg="add mod">
          <ac:chgData name="Edson Adriano" userId="38e94374d22881a3" providerId="LiveId" clId="{EDD18980-3E45-4287-8560-24571ACEB754}" dt="2024-03-03T17:47:40.465" v="820" actId="164"/>
          <ac:cxnSpMkLst>
            <pc:docMk/>
            <pc:sldMk cId="2308866928" sldId="258"/>
            <ac:cxnSpMk id="53" creationId="{41361553-CAB5-9A9C-C6D7-5507B6B2E7A6}"/>
          </ac:cxnSpMkLst>
        </pc:cxnChg>
        <pc:cxnChg chg="add mod">
          <ac:chgData name="Edson Adriano" userId="38e94374d22881a3" providerId="LiveId" clId="{EDD18980-3E45-4287-8560-24571ACEB754}" dt="2024-03-03T17:47:40.465" v="820" actId="164"/>
          <ac:cxnSpMkLst>
            <pc:docMk/>
            <pc:sldMk cId="2308866928" sldId="258"/>
            <ac:cxnSpMk id="56" creationId="{BF0483D2-4884-1C01-C156-3CDBFD919C94}"/>
          </ac:cxnSpMkLst>
        </pc:cxnChg>
      </pc:sldChg>
      <pc:sldChg chg="addSp delSp modSp new mod">
        <pc:chgData name="Edson Adriano" userId="38e94374d22881a3" providerId="LiveId" clId="{EDD18980-3E45-4287-8560-24571ACEB754}" dt="2024-03-03T19:23:55.635" v="1911" actId="164"/>
        <pc:sldMkLst>
          <pc:docMk/>
          <pc:sldMk cId="373183558" sldId="259"/>
        </pc:sldMkLst>
        <pc:spChg chg="del">
          <ac:chgData name="Edson Adriano" userId="38e94374d22881a3" providerId="LiveId" clId="{EDD18980-3E45-4287-8560-24571ACEB754}" dt="2024-03-03T17:54:39.145" v="953" actId="478"/>
          <ac:spMkLst>
            <pc:docMk/>
            <pc:sldMk cId="373183558" sldId="259"/>
            <ac:spMk id="2" creationId="{B9694E6F-7407-FC26-BF25-C5069A35CB45}"/>
          </ac:spMkLst>
        </pc:spChg>
        <pc:spChg chg="del">
          <ac:chgData name="Edson Adriano" userId="38e94374d22881a3" providerId="LiveId" clId="{EDD18980-3E45-4287-8560-24571ACEB754}" dt="2024-03-03T17:54:39.145" v="953" actId="478"/>
          <ac:spMkLst>
            <pc:docMk/>
            <pc:sldMk cId="373183558" sldId="259"/>
            <ac:spMk id="3" creationId="{5920A813-0D8A-D107-14B6-9990462E517F}"/>
          </ac:spMkLst>
        </pc:spChg>
        <pc:spChg chg="add del mod">
          <ac:chgData name="Edson Adriano" userId="38e94374d22881a3" providerId="LiveId" clId="{EDD18980-3E45-4287-8560-24571ACEB754}" dt="2024-03-03T19:23:00.567" v="1906" actId="478"/>
          <ac:spMkLst>
            <pc:docMk/>
            <pc:sldMk cId="373183558" sldId="259"/>
            <ac:spMk id="4" creationId="{BD74BD9D-43AC-AC20-B274-7E6B3FA875EB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5" creationId="{31B0CE24-55FA-BA4C-E55C-BB9F8BDF04B9}"/>
          </ac:spMkLst>
        </pc:spChg>
        <pc:spChg chg="add del mod">
          <ac:chgData name="Edson Adriano" userId="38e94374d22881a3" providerId="LiveId" clId="{EDD18980-3E45-4287-8560-24571ACEB754}" dt="2024-03-03T18:27:18.045" v="1017" actId="478"/>
          <ac:spMkLst>
            <pc:docMk/>
            <pc:sldMk cId="373183558" sldId="259"/>
            <ac:spMk id="11" creationId="{15AC495B-59DB-D1B0-3910-B55A1FD07D97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12" creationId="{2060D5F8-2437-68E4-03AE-D46695E398F4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15" creationId="{A49CB3BE-B5CB-C5F5-2433-C382CBD75F94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18" creationId="{31AF9803-7DD7-686A-ABC4-F9B59C6FADAE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21" creationId="{CAA28526-11CD-AEE7-A856-DEE853F5E3CE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25" creationId="{1058060E-83F2-A347-BAF9-9384A70721B5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33" creationId="{8D1C9392-D048-7F93-2BA5-CFC4C0010063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34" creationId="{9032AE5B-891D-A198-9CC2-D602253F281A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35" creationId="{0D954F16-F180-B9F6-745E-D19C9A475E0C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36" creationId="{185C86E0-CD3C-9672-ECE0-A384F287F557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41" creationId="{B5BCAF66-A1D6-965D-6745-9D3F7583977A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42" creationId="{7937B3E8-74EB-2C5A-44E8-8AD6D4C8B335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43" creationId="{02E8A9E9-FA23-A911-EB78-468E04429CD5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52" creationId="{7093A8DC-197F-EE4F-A3FB-87F839AF41EA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53" creationId="{4F378ECB-97F1-A464-ECC1-1F9C0BD08D1E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54" creationId="{4B25DE54-90F9-B60D-4824-639111F2E2E9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55" creationId="{75B93E32-C2F9-89AD-666A-377F1B508BC0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56" creationId="{2182E7B3-87FE-8C9D-F35C-AAEAF80C41A1}"/>
          </ac:spMkLst>
        </pc:spChg>
        <pc:spChg chg="add mod">
          <ac:chgData name="Edson Adriano" userId="38e94374d22881a3" providerId="LiveId" clId="{EDD18980-3E45-4287-8560-24571ACEB754}" dt="2024-03-03T19:23:55.635" v="1911" actId="164"/>
          <ac:spMkLst>
            <pc:docMk/>
            <pc:sldMk cId="373183558" sldId="259"/>
            <ac:spMk id="57" creationId="{9297E138-13ED-DFA4-2986-0A99FEA31980}"/>
          </ac:spMkLst>
        </pc:spChg>
        <pc:grpChg chg="add mod">
          <ac:chgData name="Edson Adriano" userId="38e94374d22881a3" providerId="LiveId" clId="{EDD18980-3E45-4287-8560-24571ACEB754}" dt="2024-03-03T19:23:55.635" v="1911" actId="164"/>
          <ac:grpSpMkLst>
            <pc:docMk/>
            <pc:sldMk cId="373183558" sldId="259"/>
            <ac:grpSpMk id="58" creationId="{FDE7287A-4924-6DA8-B01E-7BE5C4374D7D}"/>
          </ac:grpSpMkLst>
        </pc:grpChg>
        <pc:picChg chg="add mod modCrop">
          <ac:chgData name="Edson Adriano" userId="38e94374d22881a3" providerId="LiveId" clId="{EDD18980-3E45-4287-8560-24571ACEB754}" dt="2024-03-03T19:23:55.635" v="1911" actId="164"/>
          <ac:picMkLst>
            <pc:docMk/>
            <pc:sldMk cId="373183558" sldId="259"/>
            <ac:picMk id="6" creationId="{A2A7FAD7-1BAE-9F13-3D56-810CE710A5D8}"/>
          </ac:picMkLst>
        </pc:picChg>
        <pc:picChg chg="add del mod">
          <ac:chgData name="Edson Adriano" userId="38e94374d22881a3" providerId="LiveId" clId="{EDD18980-3E45-4287-8560-24571ACEB754}" dt="2024-03-03T18:27:18.045" v="1017" actId="478"/>
          <ac:picMkLst>
            <pc:docMk/>
            <pc:sldMk cId="373183558" sldId="259"/>
            <ac:picMk id="8" creationId="{447B0F86-46D1-C405-7AC4-BC9803432DFE}"/>
          </ac:picMkLst>
        </pc:picChg>
        <pc:picChg chg="add mod">
          <ac:chgData name="Edson Adriano" userId="38e94374d22881a3" providerId="LiveId" clId="{EDD18980-3E45-4287-8560-24571ACEB754}" dt="2024-03-03T19:23:55.635" v="1911" actId="164"/>
          <ac:picMkLst>
            <pc:docMk/>
            <pc:sldMk cId="373183558" sldId="259"/>
            <ac:picMk id="10" creationId="{0FD73E44-0F9B-B036-45C2-0A52720FA335}"/>
          </ac:picMkLst>
        </pc:picChg>
        <pc:picChg chg="add mod">
          <ac:chgData name="Edson Adriano" userId="38e94374d22881a3" providerId="LiveId" clId="{EDD18980-3E45-4287-8560-24571ACEB754}" dt="2024-03-03T19:23:55.635" v="1911" actId="164"/>
          <ac:picMkLst>
            <pc:docMk/>
            <pc:sldMk cId="373183558" sldId="259"/>
            <ac:picMk id="14" creationId="{240B0562-CF15-5C1F-EF3C-999D0ECA4F13}"/>
          </ac:picMkLst>
        </pc:picChg>
        <pc:picChg chg="add mod">
          <ac:chgData name="Edson Adriano" userId="38e94374d22881a3" providerId="LiveId" clId="{EDD18980-3E45-4287-8560-24571ACEB754}" dt="2024-03-03T19:23:55.635" v="1911" actId="164"/>
          <ac:picMkLst>
            <pc:docMk/>
            <pc:sldMk cId="373183558" sldId="259"/>
            <ac:picMk id="17" creationId="{6E569AFF-3F64-0EDD-3FEB-BC6ED771E77A}"/>
          </ac:picMkLst>
        </pc:picChg>
        <pc:picChg chg="add mod">
          <ac:chgData name="Edson Adriano" userId="38e94374d22881a3" providerId="LiveId" clId="{EDD18980-3E45-4287-8560-24571ACEB754}" dt="2024-03-03T19:23:55.635" v="1911" actId="164"/>
          <ac:picMkLst>
            <pc:docMk/>
            <pc:sldMk cId="373183558" sldId="259"/>
            <ac:picMk id="20" creationId="{E31727AD-D267-2CEB-0701-3EBFDFE012D5}"/>
          </ac:picMkLst>
        </pc:picChg>
        <pc:picChg chg="add mod">
          <ac:chgData name="Edson Adriano" userId="38e94374d22881a3" providerId="LiveId" clId="{EDD18980-3E45-4287-8560-24571ACEB754}" dt="2024-03-03T19:23:55.635" v="1911" actId="164"/>
          <ac:picMkLst>
            <pc:docMk/>
            <pc:sldMk cId="373183558" sldId="259"/>
            <ac:picMk id="23" creationId="{ABE41442-3D0E-090E-C073-33B17690736D}"/>
          </ac:picMkLst>
        </pc:picChg>
        <pc:picChg chg="add mod">
          <ac:chgData name="Edson Adriano" userId="38e94374d22881a3" providerId="LiveId" clId="{EDD18980-3E45-4287-8560-24571ACEB754}" dt="2024-03-03T18:43:45.147" v="1158"/>
          <ac:picMkLst>
            <pc:docMk/>
            <pc:sldMk cId="373183558" sldId="259"/>
            <ac:picMk id="24" creationId="{90A86F10-E7B8-A720-2E8E-2C8D0736C896}"/>
          </ac:picMkLst>
        </pc:picChg>
        <pc:cxnChg chg="add del mod">
          <ac:chgData name="Edson Adriano" userId="38e94374d22881a3" providerId="LiveId" clId="{EDD18980-3E45-4287-8560-24571ACEB754}" dt="2024-03-03T18:48:20.174" v="1253" actId="11529"/>
          <ac:cxnSpMkLst>
            <pc:docMk/>
            <pc:sldMk cId="373183558" sldId="259"/>
            <ac:cxnSpMk id="27" creationId="{350829A6-4C37-FB6D-7678-5DD43D6E9960}"/>
          </ac:cxnSpMkLst>
        </pc:cxnChg>
        <pc:cxnChg chg="add mod">
          <ac:chgData name="Edson Adriano" userId="38e94374d22881a3" providerId="LiveId" clId="{EDD18980-3E45-4287-8560-24571ACEB754}" dt="2024-03-03T18:48:16.533" v="1249" actId="1076"/>
          <ac:cxnSpMkLst>
            <pc:docMk/>
            <pc:sldMk cId="373183558" sldId="259"/>
            <ac:cxnSpMk id="29" creationId="{FCB4DE9F-9C19-3399-70FF-1BC5876E41BA}"/>
          </ac:cxnSpMkLst>
        </pc:cxnChg>
        <pc:cxnChg chg="add mod">
          <ac:chgData name="Edson Adriano" userId="38e94374d22881a3" providerId="LiveId" clId="{EDD18980-3E45-4287-8560-24571ACEB754}" dt="2024-03-03T18:48:15.698" v="1248" actId="1076"/>
          <ac:cxnSpMkLst>
            <pc:docMk/>
            <pc:sldMk cId="373183558" sldId="259"/>
            <ac:cxnSpMk id="30" creationId="{72DE2C53-0D56-0A04-2D61-81ACBD9AD1CB}"/>
          </ac:cxnSpMkLst>
        </pc:cxnChg>
        <pc:cxnChg chg="add mod">
          <ac:chgData name="Edson Adriano" userId="38e94374d22881a3" providerId="LiveId" clId="{EDD18980-3E45-4287-8560-24571ACEB754}" dt="2024-03-03T18:48:15.146" v="1247" actId="1076"/>
          <ac:cxnSpMkLst>
            <pc:docMk/>
            <pc:sldMk cId="373183558" sldId="259"/>
            <ac:cxnSpMk id="31" creationId="{3C8E9066-9E31-0500-8E46-73754565A209}"/>
          </ac:cxnSpMkLst>
        </pc:cxnChg>
        <pc:cxnChg chg="add mod">
          <ac:chgData name="Edson Adriano" userId="38e94374d22881a3" providerId="LiveId" clId="{EDD18980-3E45-4287-8560-24571ACEB754}" dt="2024-03-03T19:23:55.635" v="1911" actId="164"/>
          <ac:cxnSpMkLst>
            <pc:docMk/>
            <pc:sldMk cId="373183558" sldId="259"/>
            <ac:cxnSpMk id="38" creationId="{C1C79F4E-1C70-1229-04D7-6B22B6168771}"/>
          </ac:cxnSpMkLst>
        </pc:cxnChg>
        <pc:cxnChg chg="add mod">
          <ac:chgData name="Edson Adriano" userId="38e94374d22881a3" providerId="LiveId" clId="{EDD18980-3E45-4287-8560-24571ACEB754}" dt="2024-03-03T19:23:55.635" v="1911" actId="164"/>
          <ac:cxnSpMkLst>
            <pc:docMk/>
            <pc:sldMk cId="373183558" sldId="259"/>
            <ac:cxnSpMk id="40" creationId="{921496F5-E301-34AC-4BAF-BA384965B86F}"/>
          </ac:cxnSpMkLst>
        </pc:cxnChg>
        <pc:cxnChg chg="add mod">
          <ac:chgData name="Edson Adriano" userId="38e94374d22881a3" providerId="LiveId" clId="{EDD18980-3E45-4287-8560-24571ACEB754}" dt="2024-03-03T19:23:55.635" v="1911" actId="164"/>
          <ac:cxnSpMkLst>
            <pc:docMk/>
            <pc:sldMk cId="373183558" sldId="259"/>
            <ac:cxnSpMk id="44" creationId="{6C745FE7-F032-8AB2-7A24-A50FCCAF2F09}"/>
          </ac:cxnSpMkLst>
        </pc:cxnChg>
        <pc:cxnChg chg="add mod">
          <ac:chgData name="Edson Adriano" userId="38e94374d22881a3" providerId="LiveId" clId="{EDD18980-3E45-4287-8560-24571ACEB754}" dt="2024-03-03T19:23:55.635" v="1911" actId="164"/>
          <ac:cxnSpMkLst>
            <pc:docMk/>
            <pc:sldMk cId="373183558" sldId="259"/>
            <ac:cxnSpMk id="46" creationId="{95EA2651-2462-D59C-0235-81276BB18C9C}"/>
          </ac:cxnSpMkLst>
        </pc:cxnChg>
        <pc:cxnChg chg="add mod">
          <ac:chgData name="Edson Adriano" userId="38e94374d22881a3" providerId="LiveId" clId="{EDD18980-3E45-4287-8560-24571ACEB754}" dt="2024-03-03T19:23:55.635" v="1911" actId="164"/>
          <ac:cxnSpMkLst>
            <pc:docMk/>
            <pc:sldMk cId="373183558" sldId="259"/>
            <ac:cxnSpMk id="47" creationId="{794CE4B2-DD10-DF00-F9A5-E83FF1C538A7}"/>
          </ac:cxnSpMkLst>
        </pc:cxnChg>
        <pc:cxnChg chg="add mod">
          <ac:chgData name="Edson Adriano" userId="38e94374d22881a3" providerId="LiveId" clId="{EDD18980-3E45-4287-8560-24571ACEB754}" dt="2024-03-03T19:23:55.635" v="1911" actId="164"/>
          <ac:cxnSpMkLst>
            <pc:docMk/>
            <pc:sldMk cId="373183558" sldId="259"/>
            <ac:cxnSpMk id="49" creationId="{0D0A6CCC-6335-44C1-BCF5-8E5BA0F1F1AB}"/>
          </ac:cxnSpMkLst>
        </pc:cxnChg>
      </pc:sldChg>
      <pc:sldChg chg="addSp delSp modSp new mod">
        <pc:chgData name="Edson Adriano" userId="38e94374d22881a3" providerId="LiveId" clId="{EDD18980-3E45-4287-8560-24571ACEB754}" dt="2024-03-03T19:34:04.956" v="1985" actId="20577"/>
        <pc:sldMkLst>
          <pc:docMk/>
          <pc:sldMk cId="3757453335" sldId="260"/>
        </pc:sldMkLst>
        <pc:spChg chg="del">
          <ac:chgData name="Edson Adriano" userId="38e94374d22881a3" providerId="LiveId" clId="{EDD18980-3E45-4287-8560-24571ACEB754}" dt="2024-03-03T19:24:04.943" v="1913" actId="478"/>
          <ac:spMkLst>
            <pc:docMk/>
            <pc:sldMk cId="3757453335" sldId="260"/>
            <ac:spMk id="2" creationId="{AF89B4B3-27A4-3FF3-B8FB-D98CA06CBC2A}"/>
          </ac:spMkLst>
        </pc:spChg>
        <pc:spChg chg="del">
          <ac:chgData name="Edson Adriano" userId="38e94374d22881a3" providerId="LiveId" clId="{EDD18980-3E45-4287-8560-24571ACEB754}" dt="2024-03-03T19:24:04.943" v="1913" actId="478"/>
          <ac:spMkLst>
            <pc:docMk/>
            <pc:sldMk cId="3757453335" sldId="260"/>
            <ac:spMk id="3" creationId="{9D98A0F0-3885-BB06-34D8-7D4EEAD958B9}"/>
          </ac:spMkLst>
        </pc:spChg>
        <pc:spChg chg="add mod">
          <ac:chgData name="Edson Adriano" userId="38e94374d22881a3" providerId="LiveId" clId="{EDD18980-3E45-4287-8560-24571ACEB754}" dt="2024-03-03T19:34:04.956" v="1985" actId="20577"/>
          <ac:spMkLst>
            <pc:docMk/>
            <pc:sldMk cId="3757453335" sldId="260"/>
            <ac:spMk id="4" creationId="{7226F06E-280F-A9F7-4255-827185CD172C}"/>
          </ac:spMkLst>
        </pc:spChg>
        <pc:grpChg chg="add mod">
          <ac:chgData name="Edson Adriano" userId="38e94374d22881a3" providerId="LiveId" clId="{EDD18980-3E45-4287-8560-24571ACEB754}" dt="2024-03-03T19:33:45.795" v="1982" actId="1076"/>
          <ac:grpSpMkLst>
            <pc:docMk/>
            <pc:sldMk cId="3757453335" sldId="260"/>
            <ac:grpSpMk id="7" creationId="{43E6E519-12C1-5463-81A5-E1E61A26F2D4}"/>
          </ac:grpSpMkLst>
        </pc:grpChg>
        <pc:picChg chg="add mod">
          <ac:chgData name="Edson Adriano" userId="38e94374d22881a3" providerId="LiveId" clId="{EDD18980-3E45-4287-8560-24571ACEB754}" dt="2024-03-03T19:33:42.086" v="1981" actId="164"/>
          <ac:picMkLst>
            <pc:docMk/>
            <pc:sldMk cId="3757453335" sldId="260"/>
            <ac:picMk id="6" creationId="{99A50404-7272-A47D-E24E-D721E0AC32D9}"/>
          </ac:picMkLst>
        </pc:picChg>
      </pc:sldChg>
    </pc:docChg>
  </pc:docChgLst>
  <pc:docChgLst>
    <pc:chgData name="Edson Adriano" userId="38e94374d22881a3" providerId="LiveId" clId="{6EA9FEA2-F441-4C9A-AB6B-94BB8D8D6C68}"/>
    <pc:docChg chg="modSld">
      <pc:chgData name="Edson Adriano" userId="38e94374d22881a3" providerId="LiveId" clId="{6EA9FEA2-F441-4C9A-AB6B-94BB8D8D6C68}" dt="2024-03-13T12:35:02.071" v="33" actId="14100"/>
      <pc:docMkLst>
        <pc:docMk/>
      </pc:docMkLst>
      <pc:sldChg chg="modSp mod">
        <pc:chgData name="Edson Adriano" userId="38e94374d22881a3" providerId="LiveId" clId="{6EA9FEA2-F441-4C9A-AB6B-94BB8D8D6C68}" dt="2024-03-13T12:33:04.993" v="22" actId="20577"/>
        <pc:sldMkLst>
          <pc:docMk/>
          <pc:sldMk cId="2931561781" sldId="257"/>
        </pc:sldMkLst>
        <pc:spChg chg="mod">
          <ac:chgData name="Edson Adriano" userId="38e94374d22881a3" providerId="LiveId" clId="{6EA9FEA2-F441-4C9A-AB6B-94BB8D8D6C68}" dt="2024-03-13T12:33:04.993" v="22" actId="20577"/>
          <ac:spMkLst>
            <pc:docMk/>
            <pc:sldMk cId="2931561781" sldId="257"/>
            <ac:spMk id="7" creationId="{D2C1EC59-229E-D5E3-B5A5-27B063CC3C44}"/>
          </ac:spMkLst>
        </pc:spChg>
      </pc:sldChg>
      <pc:sldChg chg="modSp mod">
        <pc:chgData name="Edson Adriano" userId="38e94374d22881a3" providerId="LiveId" clId="{6EA9FEA2-F441-4C9A-AB6B-94BB8D8D6C68}" dt="2024-03-13T12:31:34.064" v="15" actId="20577"/>
        <pc:sldMkLst>
          <pc:docMk/>
          <pc:sldMk cId="2308866928" sldId="258"/>
        </pc:sldMkLst>
        <pc:spChg chg="mod">
          <ac:chgData name="Edson Adriano" userId="38e94374d22881a3" providerId="LiveId" clId="{6EA9FEA2-F441-4C9A-AB6B-94BB8D8D6C68}" dt="2024-03-13T12:31:34.064" v="15" actId="20577"/>
          <ac:spMkLst>
            <pc:docMk/>
            <pc:sldMk cId="2308866928" sldId="258"/>
            <ac:spMk id="7" creationId="{7C6E342A-477D-4E16-A147-711E07AD639E}"/>
          </ac:spMkLst>
        </pc:spChg>
      </pc:sldChg>
      <pc:sldChg chg="modSp mod">
        <pc:chgData name="Edson Adriano" userId="38e94374d22881a3" providerId="LiveId" clId="{6EA9FEA2-F441-4C9A-AB6B-94BB8D8D6C68}" dt="2024-03-13T12:35:02.071" v="33" actId="14100"/>
        <pc:sldMkLst>
          <pc:docMk/>
          <pc:sldMk cId="373183558" sldId="259"/>
        </pc:sldMkLst>
        <pc:spChg chg="mod">
          <ac:chgData name="Edson Adriano" userId="38e94374d22881a3" providerId="LiveId" clId="{6EA9FEA2-F441-4C9A-AB6B-94BB8D8D6C68}" dt="2024-03-13T12:34:06.086" v="30" actId="114"/>
          <ac:spMkLst>
            <pc:docMk/>
            <pc:sldMk cId="373183558" sldId="259"/>
            <ac:spMk id="5" creationId="{31B0CE24-55FA-BA4C-E55C-BB9F8BDF04B9}"/>
          </ac:spMkLst>
        </pc:spChg>
        <pc:grpChg chg="mod">
          <ac:chgData name="Edson Adriano" userId="38e94374d22881a3" providerId="LiveId" clId="{6EA9FEA2-F441-4C9A-AB6B-94BB8D8D6C68}" dt="2024-03-13T12:34:49.710" v="31" actId="1037"/>
          <ac:grpSpMkLst>
            <pc:docMk/>
            <pc:sldMk cId="373183558" sldId="259"/>
            <ac:grpSpMk id="58" creationId="{FDE7287A-4924-6DA8-B01E-7BE5C4374D7D}"/>
          </ac:grpSpMkLst>
        </pc:grpChg>
        <pc:picChg chg="mod">
          <ac:chgData name="Edson Adriano" userId="38e94374d22881a3" providerId="LiveId" clId="{6EA9FEA2-F441-4C9A-AB6B-94BB8D8D6C68}" dt="2024-03-13T12:35:02.071" v="33" actId="14100"/>
          <ac:picMkLst>
            <pc:docMk/>
            <pc:sldMk cId="373183558" sldId="259"/>
            <ac:picMk id="17" creationId="{6E569AFF-3F64-0EDD-3FEB-BC6ED771E77A}"/>
          </ac:picMkLst>
        </pc:picChg>
      </pc:sldChg>
    </pc:docChg>
  </pc:docChgLst>
  <pc:docChgLst>
    <pc:chgData name="Paul Long" userId="11409ae2-79c0-4fa7-8955-b04ea8aea2b0" providerId="ADAL" clId="{5F5F52BA-E7BA-44C4-BCCC-7582A819B342}"/>
    <pc:docChg chg="custSel modSld">
      <pc:chgData name="Paul Long" userId="11409ae2-79c0-4fa7-8955-b04ea8aea2b0" providerId="ADAL" clId="{5F5F52BA-E7BA-44C4-BCCC-7582A819B342}" dt="2024-04-26T08:42:09.825" v="61" actId="20577"/>
      <pc:docMkLst>
        <pc:docMk/>
      </pc:docMkLst>
      <pc:sldChg chg="modSp mod">
        <pc:chgData name="Paul Long" userId="11409ae2-79c0-4fa7-8955-b04ea8aea2b0" providerId="ADAL" clId="{5F5F52BA-E7BA-44C4-BCCC-7582A819B342}" dt="2024-04-26T08:41:30.249" v="49" actId="20577"/>
        <pc:sldMkLst>
          <pc:docMk/>
          <pc:sldMk cId="2931561781" sldId="257"/>
        </pc:sldMkLst>
        <pc:spChg chg="mod">
          <ac:chgData name="Paul Long" userId="11409ae2-79c0-4fa7-8955-b04ea8aea2b0" providerId="ADAL" clId="{5F5F52BA-E7BA-44C4-BCCC-7582A819B342}" dt="2024-04-26T08:41:30.249" v="49" actId="20577"/>
          <ac:spMkLst>
            <pc:docMk/>
            <pc:sldMk cId="2931561781" sldId="257"/>
            <ac:spMk id="7" creationId="{D2C1EC59-229E-D5E3-B5A5-27B063CC3C44}"/>
          </ac:spMkLst>
        </pc:spChg>
      </pc:sldChg>
      <pc:sldChg chg="modSp mod">
        <pc:chgData name="Paul Long" userId="11409ae2-79c0-4fa7-8955-b04ea8aea2b0" providerId="ADAL" clId="{5F5F52BA-E7BA-44C4-BCCC-7582A819B342}" dt="2024-04-26T08:40:55.360" v="38" actId="20577"/>
        <pc:sldMkLst>
          <pc:docMk/>
          <pc:sldMk cId="2308866928" sldId="258"/>
        </pc:sldMkLst>
        <pc:spChg chg="mod">
          <ac:chgData name="Paul Long" userId="11409ae2-79c0-4fa7-8955-b04ea8aea2b0" providerId="ADAL" clId="{5F5F52BA-E7BA-44C4-BCCC-7582A819B342}" dt="2024-04-26T08:40:55.360" v="38" actId="20577"/>
          <ac:spMkLst>
            <pc:docMk/>
            <pc:sldMk cId="2308866928" sldId="258"/>
            <ac:spMk id="7" creationId="{7C6E342A-477D-4E16-A147-711E07AD639E}"/>
          </ac:spMkLst>
        </pc:spChg>
      </pc:sldChg>
      <pc:sldChg chg="modSp mod">
        <pc:chgData name="Paul Long" userId="11409ae2-79c0-4fa7-8955-b04ea8aea2b0" providerId="ADAL" clId="{5F5F52BA-E7BA-44C4-BCCC-7582A819B342}" dt="2024-04-26T08:42:09.825" v="61" actId="20577"/>
        <pc:sldMkLst>
          <pc:docMk/>
          <pc:sldMk cId="373183558" sldId="259"/>
        </pc:sldMkLst>
        <pc:spChg chg="mod">
          <ac:chgData name="Paul Long" userId="11409ae2-79c0-4fa7-8955-b04ea8aea2b0" providerId="ADAL" clId="{5F5F52BA-E7BA-44C4-BCCC-7582A819B342}" dt="2024-04-26T08:42:09.825" v="61" actId="20577"/>
          <ac:spMkLst>
            <pc:docMk/>
            <pc:sldMk cId="373183558" sldId="259"/>
            <ac:spMk id="5" creationId="{31B0CE24-55FA-BA4C-E55C-BB9F8BDF04B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40391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18815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1964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79104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85987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42625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51530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44529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5234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46003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01210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B44E7B-037E-4691-ABBD-8E39B26CC7A1}" type="datetimeFigureOut">
              <a:rPr lang="pt-BR" smtClean="0"/>
              <a:t>26/04/2024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E9886FB-5FCA-4BAF-A5CF-AC258FA1ABA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45116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7.wdp"/><Relationship Id="rId5" Type="http://schemas.openxmlformats.org/officeDocument/2006/relationships/image" Target="../media/image9.png"/><Relationship Id="rId4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0.wdp"/><Relationship Id="rId3" Type="http://schemas.openxmlformats.org/officeDocument/2006/relationships/image" Target="../media/image11.png"/><Relationship Id="rId7" Type="http://schemas.openxmlformats.org/officeDocument/2006/relationships/image" Target="../media/image13.png"/><Relationship Id="rId12" Type="http://schemas.microsoft.com/office/2007/relationships/hdphoto" Target="../media/hdphoto12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microsoft.com/office/2007/relationships/hdphoto" Target="../media/hdphoto9.wdp"/><Relationship Id="rId11" Type="http://schemas.openxmlformats.org/officeDocument/2006/relationships/image" Target="../media/image15.png"/><Relationship Id="rId5" Type="http://schemas.openxmlformats.org/officeDocument/2006/relationships/image" Target="../media/image12.png"/><Relationship Id="rId10" Type="http://schemas.microsoft.com/office/2007/relationships/hdphoto" Target="../media/hdphoto11.wdp"/><Relationship Id="rId4" Type="http://schemas.microsoft.com/office/2007/relationships/hdphoto" Target="../media/hdphoto8.wdp"/><Relationship Id="rId9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06671DF1-B8B5-4DAD-A3DF-92686A13A72C}"/>
              </a:ext>
            </a:extLst>
          </p:cNvPr>
          <p:cNvGrpSpPr/>
          <p:nvPr/>
        </p:nvGrpSpPr>
        <p:grpSpPr>
          <a:xfrm>
            <a:off x="523875" y="548088"/>
            <a:ext cx="5741836" cy="6412664"/>
            <a:chOff x="685800" y="2232108"/>
            <a:chExt cx="5741836" cy="6412664"/>
          </a:xfrm>
        </p:grpSpPr>
        <p:pic>
          <p:nvPicPr>
            <p:cNvPr id="22" name="Imagem 21">
              <a:extLst>
                <a:ext uri="{FF2B5EF4-FFF2-40B4-BE49-F238E27FC236}">
                  <a16:creationId xmlns:a16="http://schemas.microsoft.com/office/drawing/2014/main" id="{57A741FA-81F6-7D01-DF75-76BA6EFEBF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3830782" y="3769361"/>
              <a:ext cx="2548360" cy="2382883"/>
            </a:xfrm>
            <a:prstGeom prst="rect">
              <a:avLst/>
            </a:prstGeom>
          </p:spPr>
        </p:pic>
        <p:pic>
          <p:nvPicPr>
            <p:cNvPr id="6" name="Imagem 5" descr="Peixe dentro de água verde&#10;&#10;Descrição gerada automaticamente com confiança média">
              <a:extLst>
                <a:ext uri="{FF2B5EF4-FFF2-40B4-BE49-F238E27FC236}">
                  <a16:creationId xmlns:a16="http://schemas.microsoft.com/office/drawing/2014/main" id="{8C49908F-9BF1-AA74-76C7-F3844CEFCCF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 flipH="1">
              <a:off x="748685" y="2295374"/>
              <a:ext cx="3118580" cy="1452282"/>
            </a:xfrm>
            <a:prstGeom prst="rect">
              <a:avLst/>
            </a:prstGeom>
          </p:spPr>
        </p:pic>
        <p:sp>
          <p:nvSpPr>
            <p:cNvPr id="7" name="TextBox 2">
              <a:extLst>
                <a:ext uri="{FF2B5EF4-FFF2-40B4-BE49-F238E27FC236}">
                  <a16:creationId xmlns:a16="http://schemas.microsoft.com/office/drawing/2014/main" id="{7C6E342A-477D-4E16-A147-711E07AD639E}"/>
                </a:ext>
              </a:extLst>
            </p:cNvPr>
            <p:cNvSpPr txBox="1"/>
            <p:nvPr/>
          </p:nvSpPr>
          <p:spPr>
            <a:xfrm>
              <a:off x="748122" y="7259777"/>
              <a:ext cx="5638827" cy="1384995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ig. 1. </a:t>
              </a:r>
              <a:r>
                <a:rPr lang="en-GB" sz="1200" i="1" dirty="0" err="1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Plagioscion</a:t>
              </a:r>
              <a:r>
                <a:rPr lang="en-GB" sz="1200" i="1" dirty="0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200" i="1" dirty="0" err="1">
                  <a:effectLst/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quamosissimus</a:t>
              </a:r>
              <a:r>
                <a:rPr lang="en-GB" sz="1200" i="1" dirty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A) and </a:t>
              </a:r>
              <a:r>
                <a:rPr lang="en-US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eratomyxa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p. Parasitic in gallbladder (B - F).  B – D: </a:t>
              </a:r>
              <a:r>
                <a:rPr lang="en-US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eratomyxa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p. sample no. 57; E and F: </a:t>
              </a:r>
              <a:r>
                <a:rPr lang="en-US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eratomyx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sp. sample no. 58. Note the presence of young plasmodium (*), immature plasmodium 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with 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young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porogonic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tages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white arrows), and mature plasmodium 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p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with mature (black arrows) and immature (empty arrow) myxospores and 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young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porogonic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tages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white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rrows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).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Scale bars B = 10 µm, C, E, F = 20 µm, D = 50 µm.</a:t>
              </a:r>
            </a:p>
          </p:txBody>
        </p:sp>
        <p:sp>
          <p:nvSpPr>
            <p:cNvPr id="8" name="TextBox 2">
              <a:extLst>
                <a:ext uri="{FF2B5EF4-FFF2-40B4-BE49-F238E27FC236}">
                  <a16:creationId xmlns:a16="http://schemas.microsoft.com/office/drawing/2014/main" id="{A703A7F4-CEDF-E711-9781-5924632DE79A}"/>
                </a:ext>
              </a:extLst>
            </p:cNvPr>
            <p:cNvSpPr txBox="1"/>
            <p:nvPr/>
          </p:nvSpPr>
          <p:spPr>
            <a:xfrm>
              <a:off x="685801" y="2232108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Imagem 9">
              <a:extLst>
                <a:ext uri="{FF2B5EF4-FFF2-40B4-BE49-F238E27FC236}">
                  <a16:creationId xmlns:a16="http://schemas.microsoft.com/office/drawing/2014/main" id="{48CB6757-8C3D-7521-9D4F-E89B3A54266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4693399" y="2058870"/>
              <a:ext cx="1453639" cy="1923936"/>
            </a:xfrm>
            <a:prstGeom prst="rect">
              <a:avLst/>
            </a:prstGeom>
          </p:spPr>
        </p:pic>
        <p:pic>
          <p:nvPicPr>
            <p:cNvPr id="13" name="Imagem 12">
              <a:extLst>
                <a:ext uri="{FF2B5EF4-FFF2-40B4-BE49-F238E27FC236}">
                  <a16:creationId xmlns:a16="http://schemas.microsoft.com/office/drawing/2014/main" id="{9997C341-8DF1-5E00-4591-128DACA394C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6200000">
              <a:off x="1085347" y="3432599"/>
              <a:ext cx="2382059" cy="3055579"/>
            </a:xfrm>
            <a:prstGeom prst="rect">
              <a:avLst/>
            </a:prstGeom>
          </p:spPr>
        </p:pic>
        <p:pic>
          <p:nvPicPr>
            <p:cNvPr id="16" name="Imagem 15">
              <a:extLst>
                <a:ext uri="{FF2B5EF4-FFF2-40B4-BE49-F238E27FC236}">
                  <a16:creationId xmlns:a16="http://schemas.microsoft.com/office/drawing/2014/main" id="{D2BE7415-F44B-6048-C146-FBD4D88383A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3437054" y="2747725"/>
              <a:ext cx="1452282" cy="547582"/>
            </a:xfrm>
            <a:prstGeom prst="rect">
              <a:avLst/>
            </a:prstGeom>
          </p:spPr>
        </p:pic>
        <p:pic>
          <p:nvPicPr>
            <p:cNvPr id="26" name="Imagem 25">
              <a:extLst>
                <a:ext uri="{FF2B5EF4-FFF2-40B4-BE49-F238E27FC236}">
                  <a16:creationId xmlns:a16="http://schemas.microsoft.com/office/drawing/2014/main" id="{46298C8D-33E6-C0BA-D4BD-B173D83E6DB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6200000">
              <a:off x="3029210" y="3892031"/>
              <a:ext cx="1076651" cy="5638826"/>
            </a:xfrm>
            <a:prstGeom prst="rect">
              <a:avLst/>
            </a:prstGeom>
          </p:spPr>
        </p:pic>
        <p:sp>
          <p:nvSpPr>
            <p:cNvPr id="28" name="TextBox 2">
              <a:extLst>
                <a:ext uri="{FF2B5EF4-FFF2-40B4-BE49-F238E27FC236}">
                  <a16:creationId xmlns:a16="http://schemas.microsoft.com/office/drawing/2014/main" id="{B0A0316E-9723-0A09-99AC-61369B7C8573}"/>
                </a:ext>
              </a:extLst>
            </p:cNvPr>
            <p:cNvSpPr txBox="1"/>
            <p:nvPr/>
          </p:nvSpPr>
          <p:spPr>
            <a:xfrm>
              <a:off x="3804166" y="2248850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9" name="TextBox 2">
              <a:extLst>
                <a:ext uri="{FF2B5EF4-FFF2-40B4-BE49-F238E27FC236}">
                  <a16:creationId xmlns:a16="http://schemas.microsoft.com/office/drawing/2014/main" id="{9D309294-4900-FD79-518D-3185723D56F9}"/>
                </a:ext>
              </a:extLst>
            </p:cNvPr>
            <p:cNvSpPr txBox="1"/>
            <p:nvPr/>
          </p:nvSpPr>
          <p:spPr>
            <a:xfrm>
              <a:off x="6139764" y="2248850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0" name="TextBox 2">
              <a:extLst>
                <a:ext uri="{FF2B5EF4-FFF2-40B4-BE49-F238E27FC236}">
                  <a16:creationId xmlns:a16="http://schemas.microsoft.com/office/drawing/2014/main" id="{3F2AA932-0311-FA85-EF07-69737644CA4D}"/>
                </a:ext>
              </a:extLst>
            </p:cNvPr>
            <p:cNvSpPr txBox="1"/>
            <p:nvPr/>
          </p:nvSpPr>
          <p:spPr>
            <a:xfrm>
              <a:off x="685800" y="3747657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31" name="TextBox 2">
              <a:extLst>
                <a:ext uri="{FF2B5EF4-FFF2-40B4-BE49-F238E27FC236}">
                  <a16:creationId xmlns:a16="http://schemas.microsoft.com/office/drawing/2014/main" id="{02B5FC4C-78B3-2755-FE0E-82FB4B080BB4}"/>
                </a:ext>
              </a:extLst>
            </p:cNvPr>
            <p:cNvSpPr txBox="1"/>
            <p:nvPr/>
          </p:nvSpPr>
          <p:spPr>
            <a:xfrm>
              <a:off x="3780535" y="3718957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32" name="TextBox 2">
              <a:extLst>
                <a:ext uri="{FF2B5EF4-FFF2-40B4-BE49-F238E27FC236}">
                  <a16:creationId xmlns:a16="http://schemas.microsoft.com/office/drawing/2014/main" id="{7815C907-34D8-D709-4389-4231A98A5602}"/>
                </a:ext>
              </a:extLst>
            </p:cNvPr>
            <p:cNvSpPr txBox="1"/>
            <p:nvPr/>
          </p:nvSpPr>
          <p:spPr>
            <a:xfrm>
              <a:off x="695796" y="6157329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33" name="TextBox 2">
              <a:extLst>
                <a:ext uri="{FF2B5EF4-FFF2-40B4-BE49-F238E27FC236}">
                  <a16:creationId xmlns:a16="http://schemas.microsoft.com/office/drawing/2014/main" id="{BF32E3BF-6F7E-B94E-6747-4AFF112A71DB}"/>
                </a:ext>
              </a:extLst>
            </p:cNvPr>
            <p:cNvSpPr txBox="1"/>
            <p:nvPr/>
          </p:nvSpPr>
          <p:spPr>
            <a:xfrm>
              <a:off x="4030789" y="2936700"/>
              <a:ext cx="374066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4" name="TextBox 2">
              <a:extLst>
                <a:ext uri="{FF2B5EF4-FFF2-40B4-BE49-F238E27FC236}">
                  <a16:creationId xmlns:a16="http://schemas.microsoft.com/office/drawing/2014/main" id="{B69959A4-B76D-43B9-CDC5-EA2A2F883ED9}"/>
                </a:ext>
              </a:extLst>
            </p:cNvPr>
            <p:cNvSpPr txBox="1"/>
            <p:nvPr/>
          </p:nvSpPr>
          <p:spPr>
            <a:xfrm>
              <a:off x="5104962" y="2790005"/>
              <a:ext cx="374066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2">
              <a:extLst>
                <a:ext uri="{FF2B5EF4-FFF2-40B4-BE49-F238E27FC236}">
                  <a16:creationId xmlns:a16="http://schemas.microsoft.com/office/drawing/2014/main" id="{3584D202-BC1D-048E-DEEC-539BD7E292D0}"/>
                </a:ext>
              </a:extLst>
            </p:cNvPr>
            <p:cNvSpPr txBox="1"/>
            <p:nvPr/>
          </p:nvSpPr>
          <p:spPr>
            <a:xfrm>
              <a:off x="3889404" y="5491879"/>
              <a:ext cx="374066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6" name="TextBox 2">
              <a:extLst>
                <a:ext uri="{FF2B5EF4-FFF2-40B4-BE49-F238E27FC236}">
                  <a16:creationId xmlns:a16="http://schemas.microsoft.com/office/drawing/2014/main" id="{306D67DD-3298-DB27-C16D-068D44AA7A55}"/>
                </a:ext>
              </a:extLst>
            </p:cNvPr>
            <p:cNvSpPr txBox="1"/>
            <p:nvPr/>
          </p:nvSpPr>
          <p:spPr>
            <a:xfrm>
              <a:off x="6053570" y="5709376"/>
              <a:ext cx="374066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7" name="TextBox 2">
              <a:extLst>
                <a:ext uri="{FF2B5EF4-FFF2-40B4-BE49-F238E27FC236}">
                  <a16:creationId xmlns:a16="http://schemas.microsoft.com/office/drawing/2014/main" id="{7708A017-08B2-BAF6-F670-3A321063DDF4}"/>
                </a:ext>
              </a:extLst>
            </p:cNvPr>
            <p:cNvSpPr txBox="1"/>
            <p:nvPr/>
          </p:nvSpPr>
          <p:spPr>
            <a:xfrm>
              <a:off x="2362200" y="4544293"/>
              <a:ext cx="457201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2">
              <a:extLst>
                <a:ext uri="{FF2B5EF4-FFF2-40B4-BE49-F238E27FC236}">
                  <a16:creationId xmlns:a16="http://schemas.microsoft.com/office/drawing/2014/main" id="{4A226493-7DB5-90ED-6A1D-18A9FA1ED73D}"/>
                </a:ext>
              </a:extLst>
            </p:cNvPr>
            <p:cNvSpPr txBox="1"/>
            <p:nvPr/>
          </p:nvSpPr>
          <p:spPr>
            <a:xfrm>
              <a:off x="5656977" y="6434445"/>
              <a:ext cx="457201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Conector de Seta Reta 39">
              <a:extLst>
                <a:ext uri="{FF2B5EF4-FFF2-40B4-BE49-F238E27FC236}">
                  <a16:creationId xmlns:a16="http://schemas.microsoft.com/office/drawing/2014/main" id="{3AA06E24-62F7-AE48-9CB6-AEE6AA9546A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273681" y="5099483"/>
              <a:ext cx="34293" cy="27608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Conector de Seta Reta 41">
              <a:extLst>
                <a:ext uri="{FF2B5EF4-FFF2-40B4-BE49-F238E27FC236}">
                  <a16:creationId xmlns:a16="http://schemas.microsoft.com/office/drawing/2014/main" id="{BA0FAAEE-64FB-0D21-7E28-E58C9650D019}"/>
                </a:ext>
              </a:extLst>
            </p:cNvPr>
            <p:cNvCxnSpPr>
              <a:cxnSpLocks/>
            </p:cNvCxnSpPr>
            <p:nvPr/>
          </p:nvCxnSpPr>
          <p:spPr>
            <a:xfrm>
              <a:off x="1842655" y="4765964"/>
              <a:ext cx="257844" cy="17364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Conector de Seta Reta 44">
              <a:extLst>
                <a:ext uri="{FF2B5EF4-FFF2-40B4-BE49-F238E27FC236}">
                  <a16:creationId xmlns:a16="http://schemas.microsoft.com/office/drawing/2014/main" id="{FCDD7950-2A3F-03BC-438F-D0C44720F54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998693" y="4510575"/>
              <a:ext cx="34293" cy="276081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Conector de Seta Reta 45">
              <a:extLst>
                <a:ext uri="{FF2B5EF4-FFF2-40B4-BE49-F238E27FC236}">
                  <a16:creationId xmlns:a16="http://schemas.microsoft.com/office/drawing/2014/main" id="{10A87265-BFFF-5D7E-2299-E0C5D5ACFA25}"/>
                </a:ext>
              </a:extLst>
            </p:cNvPr>
            <p:cNvCxnSpPr>
              <a:cxnSpLocks/>
            </p:cNvCxnSpPr>
            <p:nvPr/>
          </p:nvCxnSpPr>
          <p:spPr>
            <a:xfrm>
              <a:off x="4336473" y="4372445"/>
              <a:ext cx="223989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Conector de Seta Reta 47">
              <a:extLst>
                <a:ext uri="{FF2B5EF4-FFF2-40B4-BE49-F238E27FC236}">
                  <a16:creationId xmlns:a16="http://schemas.microsoft.com/office/drawing/2014/main" id="{B8122649-CACE-31FE-B7D0-5214DF4BFB7E}"/>
                </a:ext>
              </a:extLst>
            </p:cNvPr>
            <p:cNvCxnSpPr>
              <a:cxnSpLocks/>
            </p:cNvCxnSpPr>
            <p:nvPr/>
          </p:nvCxnSpPr>
          <p:spPr>
            <a:xfrm>
              <a:off x="4307873" y="4648615"/>
              <a:ext cx="223989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Conector de Seta Reta 48">
              <a:extLst>
                <a:ext uri="{FF2B5EF4-FFF2-40B4-BE49-F238E27FC236}">
                  <a16:creationId xmlns:a16="http://schemas.microsoft.com/office/drawing/2014/main" id="{AD920821-2D9C-DDC4-3392-9D8FF4EEBE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71298" y="4965030"/>
              <a:ext cx="150975" cy="15987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Conector de Seta Reta 51">
              <a:extLst>
                <a:ext uri="{FF2B5EF4-FFF2-40B4-BE49-F238E27FC236}">
                  <a16:creationId xmlns:a16="http://schemas.microsoft.com/office/drawing/2014/main" id="{1770CD07-7715-2F78-EEED-EC47CEC17BCD}"/>
                </a:ext>
              </a:extLst>
            </p:cNvPr>
            <p:cNvCxnSpPr>
              <a:cxnSpLocks/>
            </p:cNvCxnSpPr>
            <p:nvPr/>
          </p:nvCxnSpPr>
          <p:spPr>
            <a:xfrm>
              <a:off x="2326471" y="6563777"/>
              <a:ext cx="257844" cy="17364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Conector de Seta Reta 52">
              <a:extLst>
                <a:ext uri="{FF2B5EF4-FFF2-40B4-BE49-F238E27FC236}">
                  <a16:creationId xmlns:a16="http://schemas.microsoft.com/office/drawing/2014/main" id="{41361553-CAB5-9A9C-C6D7-5507B6B2E7A6}"/>
                </a:ext>
              </a:extLst>
            </p:cNvPr>
            <p:cNvCxnSpPr>
              <a:cxnSpLocks/>
            </p:cNvCxnSpPr>
            <p:nvPr/>
          </p:nvCxnSpPr>
          <p:spPr>
            <a:xfrm>
              <a:off x="3701860" y="6537803"/>
              <a:ext cx="257844" cy="173641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2">
              <a:extLst>
                <a:ext uri="{FF2B5EF4-FFF2-40B4-BE49-F238E27FC236}">
                  <a16:creationId xmlns:a16="http://schemas.microsoft.com/office/drawing/2014/main" id="{6B5668CF-1B4E-4058-402D-396F53443A72}"/>
                </a:ext>
              </a:extLst>
            </p:cNvPr>
            <p:cNvSpPr txBox="1"/>
            <p:nvPr/>
          </p:nvSpPr>
          <p:spPr>
            <a:xfrm>
              <a:off x="4504609" y="4670274"/>
              <a:ext cx="309843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Seta: para Baixo 54">
              <a:extLst>
                <a:ext uri="{FF2B5EF4-FFF2-40B4-BE49-F238E27FC236}">
                  <a16:creationId xmlns:a16="http://schemas.microsoft.com/office/drawing/2014/main" id="{A1B4253D-BFEA-C479-1C61-35E999D1F875}"/>
                </a:ext>
              </a:extLst>
            </p:cNvPr>
            <p:cNvSpPr/>
            <p:nvPr/>
          </p:nvSpPr>
          <p:spPr>
            <a:xfrm>
              <a:off x="5361709" y="6310745"/>
              <a:ext cx="117319" cy="227058"/>
            </a:xfrm>
            <a:prstGeom prst="downArrow">
              <a:avLst/>
            </a:prstGeom>
            <a:noFill/>
            <a:ln w="952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cxnSp>
          <p:nvCxnSpPr>
            <p:cNvPr id="56" name="Conector de Seta Reta 55">
              <a:extLst>
                <a:ext uri="{FF2B5EF4-FFF2-40B4-BE49-F238E27FC236}">
                  <a16:creationId xmlns:a16="http://schemas.microsoft.com/office/drawing/2014/main" id="{BF0483D2-4884-1C01-C156-3CDBFD919C94}"/>
                </a:ext>
              </a:extLst>
            </p:cNvPr>
            <p:cNvCxnSpPr>
              <a:cxnSpLocks/>
            </p:cNvCxnSpPr>
            <p:nvPr/>
          </p:nvCxnSpPr>
          <p:spPr>
            <a:xfrm>
              <a:off x="2575735" y="4274679"/>
              <a:ext cx="132973" cy="21520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088669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76275AB1-1809-7743-6354-FB5BFA9EA1EF}"/>
              </a:ext>
            </a:extLst>
          </p:cNvPr>
          <p:cNvGrpSpPr/>
          <p:nvPr/>
        </p:nvGrpSpPr>
        <p:grpSpPr>
          <a:xfrm>
            <a:off x="784510" y="426168"/>
            <a:ext cx="5311490" cy="3525634"/>
            <a:chOff x="784510" y="426168"/>
            <a:chExt cx="5311490" cy="3525634"/>
          </a:xfrm>
        </p:grpSpPr>
        <p:sp>
          <p:nvSpPr>
            <p:cNvPr id="7" name="TextBox 2">
              <a:extLst>
                <a:ext uri="{FF2B5EF4-FFF2-40B4-BE49-F238E27FC236}">
                  <a16:creationId xmlns:a16="http://schemas.microsoft.com/office/drawing/2014/main" id="{D2C1EC59-229E-D5E3-B5A5-27B063CC3C44}"/>
                </a:ext>
              </a:extLst>
            </p:cNvPr>
            <p:cNvSpPr txBox="1"/>
            <p:nvPr/>
          </p:nvSpPr>
          <p:spPr>
            <a:xfrm>
              <a:off x="823913" y="2936139"/>
              <a:ext cx="5272087" cy="1015663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ig. 2. </a:t>
              </a:r>
              <a:r>
                <a:rPr lang="en-US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urimata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inornat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sample no. 70 (A) and </a:t>
              </a:r>
              <a:r>
                <a:rPr lang="en-US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Ellipsomyx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sp. parasitic in its gallbladder (B and C). Note the presence of immature plasmodia 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; a mature plasmodium 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p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harboring two myxospores (black arrows) with nematocyst inside (white arrow) and a free myxospore (empty arrow). Scale bars B = 10 µm, C = 25 µm.</a:t>
              </a:r>
              <a:endParaRPr lang="en-US" sz="1200" dirty="0">
                <a:cs typeface="Calibri"/>
              </a:endParaRPr>
            </a:p>
          </p:txBody>
        </p:sp>
        <p:pic>
          <p:nvPicPr>
            <p:cNvPr id="8" name="Picture 1" descr="Peixe em cima de uma superfície verde&#10;&#10;Descrição gerada automaticamente com confiança média">
              <a:extLst>
                <a:ext uri="{FF2B5EF4-FFF2-40B4-BE49-F238E27FC236}">
                  <a16:creationId xmlns:a16="http://schemas.microsoft.com/office/drawing/2014/main" id="{5D32BCDC-A102-28BE-36B1-02F6E0F1CB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4396"/>
            <a:stretch/>
          </p:blipFill>
          <p:spPr>
            <a:xfrm>
              <a:off x="838201" y="502368"/>
              <a:ext cx="2910840" cy="1107566"/>
            </a:xfrm>
            <a:prstGeom prst="rect">
              <a:avLst/>
            </a:prstGeom>
          </p:spPr>
        </p:pic>
        <p:pic>
          <p:nvPicPr>
            <p:cNvPr id="12" name="Imagem 11">
              <a:extLst>
                <a:ext uri="{FF2B5EF4-FFF2-40B4-BE49-F238E27FC236}">
                  <a16:creationId xmlns:a16="http://schemas.microsoft.com/office/drawing/2014/main" id="{067CDFD7-3047-BFDF-FF02-809639D9A85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771900" y="502368"/>
              <a:ext cx="2324100" cy="2446867"/>
            </a:xfrm>
            <a:prstGeom prst="rect">
              <a:avLst/>
            </a:prstGeom>
          </p:spPr>
        </p:pic>
        <p:pic>
          <p:nvPicPr>
            <p:cNvPr id="9" name="Imagem 8">
              <a:extLst>
                <a:ext uri="{FF2B5EF4-FFF2-40B4-BE49-F238E27FC236}">
                  <a16:creationId xmlns:a16="http://schemas.microsoft.com/office/drawing/2014/main" id="{A02627A0-1AE4-F817-BCEE-8135D5EC2E0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39851" y="1625174"/>
              <a:ext cx="3678809" cy="1321394"/>
            </a:xfrm>
            <a:prstGeom prst="rect">
              <a:avLst/>
            </a:prstGeom>
            <a:ln w="19050">
              <a:solidFill>
                <a:schemeClr val="bg1"/>
              </a:solidFill>
            </a:ln>
          </p:spPr>
        </p:pic>
        <p:sp>
          <p:nvSpPr>
            <p:cNvPr id="14" name="TextBox 2">
              <a:extLst>
                <a:ext uri="{FF2B5EF4-FFF2-40B4-BE49-F238E27FC236}">
                  <a16:creationId xmlns:a16="http://schemas.microsoft.com/office/drawing/2014/main" id="{5B224254-FBC1-D809-35F4-0FB33F8918BD}"/>
                </a:ext>
              </a:extLst>
            </p:cNvPr>
            <p:cNvSpPr txBox="1"/>
            <p:nvPr/>
          </p:nvSpPr>
          <p:spPr>
            <a:xfrm>
              <a:off x="784510" y="426168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2">
              <a:extLst>
                <a:ext uri="{FF2B5EF4-FFF2-40B4-BE49-F238E27FC236}">
                  <a16:creationId xmlns:a16="http://schemas.microsoft.com/office/drawing/2014/main" id="{46C176E9-016A-A724-3CB9-1977DF2C9D4E}"/>
                </a:ext>
              </a:extLst>
            </p:cNvPr>
            <p:cNvSpPr txBox="1"/>
            <p:nvPr/>
          </p:nvSpPr>
          <p:spPr>
            <a:xfrm>
              <a:off x="5830858" y="467103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6" name="TextBox 2">
              <a:extLst>
                <a:ext uri="{FF2B5EF4-FFF2-40B4-BE49-F238E27FC236}">
                  <a16:creationId xmlns:a16="http://schemas.microsoft.com/office/drawing/2014/main" id="{6BFB32C2-4408-10F6-20BA-2F1071F3B94A}"/>
                </a:ext>
              </a:extLst>
            </p:cNvPr>
            <p:cNvSpPr txBox="1"/>
            <p:nvPr/>
          </p:nvSpPr>
          <p:spPr>
            <a:xfrm>
              <a:off x="802196" y="1574389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7" name="TextBox 2">
              <a:extLst>
                <a:ext uri="{FF2B5EF4-FFF2-40B4-BE49-F238E27FC236}">
                  <a16:creationId xmlns:a16="http://schemas.microsoft.com/office/drawing/2014/main" id="{87C1D66D-18C9-717F-0D43-B06BDBFB373C}"/>
                </a:ext>
              </a:extLst>
            </p:cNvPr>
            <p:cNvSpPr txBox="1"/>
            <p:nvPr/>
          </p:nvSpPr>
          <p:spPr>
            <a:xfrm>
              <a:off x="1034764" y="1952701"/>
              <a:ext cx="374936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2">
              <a:extLst>
                <a:ext uri="{FF2B5EF4-FFF2-40B4-BE49-F238E27FC236}">
                  <a16:creationId xmlns:a16="http://schemas.microsoft.com/office/drawing/2014/main" id="{1816BAEE-15C3-9B39-8857-CF1415A7C10A}"/>
                </a:ext>
              </a:extLst>
            </p:cNvPr>
            <p:cNvSpPr txBox="1"/>
            <p:nvPr/>
          </p:nvSpPr>
          <p:spPr>
            <a:xfrm>
              <a:off x="2215864" y="2131982"/>
              <a:ext cx="374936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Conector de Seta Reta 21">
              <a:extLst>
                <a:ext uri="{FF2B5EF4-FFF2-40B4-BE49-F238E27FC236}">
                  <a16:creationId xmlns:a16="http://schemas.microsoft.com/office/drawing/2014/main" id="{F7320E20-1D6F-7ED9-B7B7-ED2C4A6133A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94070" y="2690326"/>
              <a:ext cx="220980" cy="179281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Conector de Seta Reta 22">
              <a:extLst>
                <a:ext uri="{FF2B5EF4-FFF2-40B4-BE49-F238E27FC236}">
                  <a16:creationId xmlns:a16="http://schemas.microsoft.com/office/drawing/2014/main" id="{266C0995-7CA4-C113-DF72-6899F5637E3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93783" y="1952701"/>
              <a:ext cx="187329" cy="179281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Conector de Seta Reta 24">
              <a:extLst>
                <a:ext uri="{FF2B5EF4-FFF2-40B4-BE49-F238E27FC236}">
                  <a16:creationId xmlns:a16="http://schemas.microsoft.com/office/drawing/2014/main" id="{C3923A0B-7D0E-B2FD-CAEE-8712FF9E1B10}"/>
                </a:ext>
              </a:extLst>
            </p:cNvPr>
            <p:cNvCxnSpPr>
              <a:cxnSpLocks/>
            </p:cNvCxnSpPr>
            <p:nvPr/>
          </p:nvCxnSpPr>
          <p:spPr>
            <a:xfrm>
              <a:off x="5599810" y="1882166"/>
              <a:ext cx="99950" cy="227689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">
              <a:extLst>
                <a:ext uri="{FF2B5EF4-FFF2-40B4-BE49-F238E27FC236}">
                  <a16:creationId xmlns:a16="http://schemas.microsoft.com/office/drawing/2014/main" id="{4A2632C8-AECF-242D-62E0-659BF53BA181}"/>
                </a:ext>
              </a:extLst>
            </p:cNvPr>
            <p:cNvSpPr txBox="1"/>
            <p:nvPr/>
          </p:nvSpPr>
          <p:spPr>
            <a:xfrm>
              <a:off x="3941682" y="623602"/>
              <a:ext cx="374936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">
              <a:extLst>
                <a:ext uri="{FF2B5EF4-FFF2-40B4-BE49-F238E27FC236}">
                  <a16:creationId xmlns:a16="http://schemas.microsoft.com/office/drawing/2014/main" id="{C2DD064E-1062-3177-34CE-07BA9CEE1702}"/>
                </a:ext>
              </a:extLst>
            </p:cNvPr>
            <p:cNvSpPr txBox="1"/>
            <p:nvPr/>
          </p:nvSpPr>
          <p:spPr>
            <a:xfrm>
              <a:off x="5179949" y="2119626"/>
              <a:ext cx="514937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Seta: para a Direita 29">
              <a:extLst>
                <a:ext uri="{FF2B5EF4-FFF2-40B4-BE49-F238E27FC236}">
                  <a16:creationId xmlns:a16="http://schemas.microsoft.com/office/drawing/2014/main" id="{B89ED100-9EDC-13A7-C556-87FA41F4F139}"/>
                </a:ext>
              </a:extLst>
            </p:cNvPr>
            <p:cNvSpPr/>
            <p:nvPr/>
          </p:nvSpPr>
          <p:spPr>
            <a:xfrm rot="18975535">
              <a:off x="4012397" y="1915594"/>
              <a:ext cx="179594" cy="206522"/>
            </a:xfrm>
            <a:prstGeom prst="rightArrow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</p:grpSp>
    </p:spTree>
    <p:extLst>
      <p:ext uri="{BB962C8B-B14F-4D97-AF65-F5344CB8AC3E}">
        <p14:creationId xmlns:p14="http://schemas.microsoft.com/office/powerpoint/2010/main" val="29315617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Agrupar 57">
            <a:extLst>
              <a:ext uri="{FF2B5EF4-FFF2-40B4-BE49-F238E27FC236}">
                <a16:creationId xmlns:a16="http://schemas.microsoft.com/office/drawing/2014/main" id="{FDE7287A-4924-6DA8-B01E-7BE5C4374D7D}"/>
              </a:ext>
            </a:extLst>
          </p:cNvPr>
          <p:cNvGrpSpPr/>
          <p:nvPr/>
        </p:nvGrpSpPr>
        <p:grpSpPr>
          <a:xfrm>
            <a:off x="86832" y="1185136"/>
            <a:ext cx="6757188" cy="4681830"/>
            <a:chOff x="95299" y="1185136"/>
            <a:chExt cx="6757188" cy="4681830"/>
          </a:xfrm>
        </p:grpSpPr>
        <p:sp>
          <p:nvSpPr>
            <p:cNvPr id="5" name="TextBox 2">
              <a:extLst>
                <a:ext uri="{FF2B5EF4-FFF2-40B4-BE49-F238E27FC236}">
                  <a16:creationId xmlns:a16="http://schemas.microsoft.com/office/drawing/2014/main" id="{31B0CE24-55FA-BA4C-E55C-BB9F8BDF04B9}"/>
                </a:ext>
              </a:extLst>
            </p:cNvPr>
            <p:cNvSpPr txBox="1"/>
            <p:nvPr/>
          </p:nvSpPr>
          <p:spPr>
            <a:xfrm>
              <a:off x="151850" y="4666637"/>
              <a:ext cx="6553750" cy="120032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ig. 3. </a:t>
              </a:r>
              <a:r>
                <a:rPr lang="en-GB" sz="1200" i="1" dirty="0" err="1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Hemiodus</a:t>
              </a:r>
              <a:r>
                <a:rPr lang="en-GB" sz="1200" i="1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 </a:t>
              </a:r>
              <a:r>
                <a:rPr lang="en-GB" sz="1200" i="1" dirty="0" err="1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unimaculatus</a:t>
              </a:r>
              <a:r>
                <a:rPr lang="en-GB" sz="1200" i="1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 </a:t>
              </a:r>
              <a:r>
                <a:rPr lang="en-GB" sz="1200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sample no</a:t>
              </a:r>
              <a:r>
                <a:rPr lang="en-GB" sz="1200" i="1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. </a:t>
              </a:r>
              <a:r>
                <a:rPr lang="en-GB" sz="1200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115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A) with </a:t>
              </a:r>
              <a:r>
                <a:rPr lang="en-US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eratomyxa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p. (B, C, and E) and </a:t>
              </a:r>
              <a:r>
                <a:rPr lang="en-GB" sz="1200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stages consistent with </a:t>
              </a:r>
              <a:r>
                <a:rPr lang="en-GB" sz="1200" i="1" dirty="0" err="1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Ellipsomyxa</a:t>
              </a:r>
              <a:r>
                <a:rPr lang="en-GB" sz="1200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 sp. (D and F</a:t>
              </a:r>
              <a:r>
                <a:rPr lang="en-GB" sz="120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) parasitic in</a:t>
              </a:r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gallbladder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. Note the presence of immature (white large arrows) and mature (empty arrow) plasmodia and mature myxospores with nematocysts (thin white arrows)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(B, C, 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nd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E). Observe in D, E, </a:t>
              </a:r>
              <a:r>
                <a:rPr lang="pt-B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nd</a:t>
              </a:r>
              <a:r>
                <a:rPr lang="pt-BR" sz="1200" dirty="0">
                  <a:latin typeface="Arial" panose="020B0604020202020204" pitchFamily="34" charset="0"/>
                  <a:cs typeface="Arial" panose="020B0604020202020204" pitchFamily="34" charset="0"/>
                </a:rPr>
                <a:t> F </a:t>
              </a:r>
              <a:r>
                <a:rPr lang="en-GB" sz="1200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stages consistent with the immature </a:t>
              </a:r>
              <a:r>
                <a:rPr lang="en-GB" sz="1200" i="1" dirty="0" err="1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Ellipsomyxa</a:t>
              </a:r>
              <a:r>
                <a:rPr lang="en-GB" sz="1200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 plasmodia (*) with cytoplasmic projections (thin black arrows)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cale bars B = 50 µm, C - F = 10 µm, E = 20 µm.</a:t>
              </a:r>
            </a:p>
          </p:txBody>
        </p:sp>
        <p:pic>
          <p:nvPicPr>
            <p:cNvPr id="6" name="Imagem 5" descr="Peixe em cima de uma superfície verde&#10;&#10;Descrição gerada automaticamente com confiança média">
              <a:extLst>
                <a:ext uri="{FF2B5EF4-FFF2-40B4-BE49-F238E27FC236}">
                  <a16:creationId xmlns:a16="http://schemas.microsoft.com/office/drawing/2014/main" id="{A2A7FAD7-1BAE-9F13-3D56-810CE710A5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924"/>
            <a:stretch/>
          </p:blipFill>
          <p:spPr>
            <a:xfrm rot="10800000">
              <a:off x="152400" y="1246911"/>
              <a:ext cx="3881033" cy="1715885"/>
            </a:xfrm>
            <a:prstGeom prst="rect">
              <a:avLst/>
            </a:prstGeom>
          </p:spPr>
        </p:pic>
        <p:pic>
          <p:nvPicPr>
            <p:cNvPr id="10" name="Imagem 9">
              <a:extLst>
                <a:ext uri="{FF2B5EF4-FFF2-40B4-BE49-F238E27FC236}">
                  <a16:creationId xmlns:a16="http://schemas.microsoft.com/office/drawing/2014/main" id="{0FD73E44-0F9B-B036-45C2-0A52720FA33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6200000">
              <a:off x="3665829" y="1640351"/>
              <a:ext cx="3430993" cy="2649649"/>
            </a:xfrm>
            <a:prstGeom prst="rect">
              <a:avLst/>
            </a:prstGeom>
          </p:spPr>
        </p:pic>
        <p:sp>
          <p:nvSpPr>
            <p:cNvPr id="12" name="TextBox 2">
              <a:extLst>
                <a:ext uri="{FF2B5EF4-FFF2-40B4-BE49-F238E27FC236}">
                  <a16:creationId xmlns:a16="http://schemas.microsoft.com/office/drawing/2014/main" id="{2060D5F8-2437-68E4-03AE-D46695E398F4}"/>
                </a:ext>
              </a:extLst>
            </p:cNvPr>
            <p:cNvSpPr txBox="1"/>
            <p:nvPr/>
          </p:nvSpPr>
          <p:spPr>
            <a:xfrm>
              <a:off x="5908266" y="4156245"/>
              <a:ext cx="641636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 mic</a:t>
              </a:r>
            </a:p>
          </p:txBody>
        </p:sp>
        <p:pic>
          <p:nvPicPr>
            <p:cNvPr id="14" name="Imagem 13">
              <a:extLst>
                <a:ext uri="{FF2B5EF4-FFF2-40B4-BE49-F238E27FC236}">
                  <a16:creationId xmlns:a16="http://schemas.microsoft.com/office/drawing/2014/main" id="{240B0562-CF15-5C1F-EF3C-999D0ECA4F1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339443" y="1252354"/>
              <a:ext cx="1367260" cy="1479960"/>
            </a:xfrm>
            <a:prstGeom prst="rect">
              <a:avLst/>
            </a:prstGeom>
            <a:ln w="28575">
              <a:solidFill>
                <a:schemeClr val="bg1"/>
              </a:solidFill>
            </a:ln>
          </p:spPr>
        </p:pic>
        <p:sp>
          <p:nvSpPr>
            <p:cNvPr id="15" name="TextBox 2">
              <a:extLst>
                <a:ext uri="{FF2B5EF4-FFF2-40B4-BE49-F238E27FC236}">
                  <a16:creationId xmlns:a16="http://schemas.microsoft.com/office/drawing/2014/main" id="{A49CB3BE-B5CB-C5F5-2433-C382CBD75F94}"/>
                </a:ext>
              </a:extLst>
            </p:cNvPr>
            <p:cNvSpPr txBox="1"/>
            <p:nvPr/>
          </p:nvSpPr>
          <p:spPr>
            <a:xfrm>
              <a:off x="5364480" y="2234110"/>
              <a:ext cx="797038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 mic</a:t>
              </a:r>
            </a:p>
          </p:txBody>
        </p:sp>
        <p:pic>
          <p:nvPicPr>
            <p:cNvPr id="17" name="Imagem 16">
              <a:extLst>
                <a:ext uri="{FF2B5EF4-FFF2-40B4-BE49-F238E27FC236}">
                  <a16:creationId xmlns:a16="http://schemas.microsoft.com/office/drawing/2014/main" id="{6E569AFF-3F64-0EDD-3FEB-BC6ED771E77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5400000">
              <a:off x="1242884" y="1906809"/>
              <a:ext cx="1684180" cy="3865149"/>
            </a:xfrm>
            <a:prstGeom prst="rect">
              <a:avLst/>
            </a:prstGeom>
          </p:spPr>
        </p:pic>
        <p:sp>
          <p:nvSpPr>
            <p:cNvPr id="18" name="TextBox 2">
              <a:extLst>
                <a:ext uri="{FF2B5EF4-FFF2-40B4-BE49-F238E27FC236}">
                  <a16:creationId xmlns:a16="http://schemas.microsoft.com/office/drawing/2014/main" id="{31AF9803-7DD7-686A-ABC4-F9B59C6FADAE}"/>
                </a:ext>
              </a:extLst>
            </p:cNvPr>
            <p:cNvSpPr txBox="1"/>
            <p:nvPr/>
          </p:nvSpPr>
          <p:spPr>
            <a:xfrm>
              <a:off x="1218006" y="4079444"/>
              <a:ext cx="641636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 mic</a:t>
              </a:r>
            </a:p>
          </p:txBody>
        </p:sp>
        <p:pic>
          <p:nvPicPr>
            <p:cNvPr id="20" name="Imagem 19">
              <a:extLst>
                <a:ext uri="{FF2B5EF4-FFF2-40B4-BE49-F238E27FC236}">
                  <a16:creationId xmlns:a16="http://schemas.microsoft.com/office/drawing/2014/main" id="{E31727AD-D267-2CEB-0701-3EBFDFE012D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04030" y="3582779"/>
              <a:ext cx="1419546" cy="1094398"/>
            </a:xfrm>
            <a:prstGeom prst="rect">
              <a:avLst/>
            </a:prstGeom>
            <a:ln w="28575">
              <a:solidFill>
                <a:schemeClr val="bg1"/>
              </a:solidFill>
            </a:ln>
          </p:spPr>
        </p:pic>
        <p:sp>
          <p:nvSpPr>
            <p:cNvPr id="21" name="TextBox 2">
              <a:extLst>
                <a:ext uri="{FF2B5EF4-FFF2-40B4-BE49-F238E27FC236}">
                  <a16:creationId xmlns:a16="http://schemas.microsoft.com/office/drawing/2014/main" id="{CAA28526-11CD-AEE7-A856-DEE853F5E3CE}"/>
                </a:ext>
              </a:extLst>
            </p:cNvPr>
            <p:cNvSpPr txBox="1"/>
            <p:nvPr/>
          </p:nvSpPr>
          <p:spPr>
            <a:xfrm>
              <a:off x="3375487" y="4058376"/>
              <a:ext cx="641636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 mic</a:t>
              </a:r>
            </a:p>
          </p:txBody>
        </p:sp>
        <p:pic>
          <p:nvPicPr>
            <p:cNvPr id="23" name="Imagem 22">
              <a:extLst>
                <a:ext uri="{FF2B5EF4-FFF2-40B4-BE49-F238E27FC236}">
                  <a16:creationId xmlns:a16="http://schemas.microsoft.com/office/drawing/2014/main" id="{ABE41442-3D0E-090E-C073-33B17690736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grayscl/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339443" y="2748274"/>
              <a:ext cx="1366215" cy="1238267"/>
            </a:xfrm>
            <a:prstGeom prst="rect">
              <a:avLst/>
            </a:prstGeom>
            <a:ln w="28575">
              <a:solidFill>
                <a:schemeClr val="bg1"/>
              </a:solidFill>
            </a:ln>
          </p:spPr>
        </p:pic>
        <p:sp>
          <p:nvSpPr>
            <p:cNvPr id="25" name="TextBox 2">
              <a:extLst>
                <a:ext uri="{FF2B5EF4-FFF2-40B4-BE49-F238E27FC236}">
                  <a16:creationId xmlns:a16="http://schemas.microsoft.com/office/drawing/2014/main" id="{1058060E-83F2-A347-BAF9-9384A70721B5}"/>
                </a:ext>
              </a:extLst>
            </p:cNvPr>
            <p:cNvSpPr txBox="1"/>
            <p:nvPr/>
          </p:nvSpPr>
          <p:spPr>
            <a:xfrm>
              <a:off x="6210851" y="3400294"/>
              <a:ext cx="641636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 mic</a:t>
              </a:r>
            </a:p>
          </p:txBody>
        </p:sp>
        <p:sp>
          <p:nvSpPr>
            <p:cNvPr id="33" name="Seta: para a Direita 32">
              <a:extLst>
                <a:ext uri="{FF2B5EF4-FFF2-40B4-BE49-F238E27FC236}">
                  <a16:creationId xmlns:a16="http://schemas.microsoft.com/office/drawing/2014/main" id="{8D1C9392-D048-7F93-2BA5-CFC4C0010063}"/>
                </a:ext>
              </a:extLst>
            </p:cNvPr>
            <p:cNvSpPr/>
            <p:nvPr/>
          </p:nvSpPr>
          <p:spPr>
            <a:xfrm rot="17955788">
              <a:off x="1862690" y="3855555"/>
              <a:ext cx="239687" cy="119324"/>
            </a:xfrm>
            <a:prstGeom prst="right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34" name="Seta: para a Direita 33">
              <a:extLst>
                <a:ext uri="{FF2B5EF4-FFF2-40B4-BE49-F238E27FC236}">
                  <a16:creationId xmlns:a16="http://schemas.microsoft.com/office/drawing/2014/main" id="{9032AE5B-891D-A198-9CC2-D602253F281A}"/>
                </a:ext>
              </a:extLst>
            </p:cNvPr>
            <p:cNvSpPr/>
            <p:nvPr/>
          </p:nvSpPr>
          <p:spPr>
            <a:xfrm rot="17955788">
              <a:off x="2140364" y="3886068"/>
              <a:ext cx="239687" cy="119324"/>
            </a:xfrm>
            <a:prstGeom prst="right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35" name="Seta: para a Direita 34">
              <a:extLst>
                <a:ext uri="{FF2B5EF4-FFF2-40B4-BE49-F238E27FC236}">
                  <a16:creationId xmlns:a16="http://schemas.microsoft.com/office/drawing/2014/main" id="{0D954F16-F180-B9F6-745E-D19C9A475E0C}"/>
                </a:ext>
              </a:extLst>
            </p:cNvPr>
            <p:cNvSpPr/>
            <p:nvPr/>
          </p:nvSpPr>
          <p:spPr>
            <a:xfrm rot="17955788">
              <a:off x="4332365" y="2451446"/>
              <a:ext cx="239687" cy="119324"/>
            </a:xfrm>
            <a:prstGeom prst="right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36" name="Seta: para a Direita 35">
              <a:extLst>
                <a:ext uri="{FF2B5EF4-FFF2-40B4-BE49-F238E27FC236}">
                  <a16:creationId xmlns:a16="http://schemas.microsoft.com/office/drawing/2014/main" id="{185C86E0-CD3C-9672-ECE0-A384F287F557}"/>
                </a:ext>
              </a:extLst>
            </p:cNvPr>
            <p:cNvSpPr/>
            <p:nvPr/>
          </p:nvSpPr>
          <p:spPr>
            <a:xfrm rot="17955788">
              <a:off x="5330230" y="4349252"/>
              <a:ext cx="239687" cy="119324"/>
            </a:xfrm>
            <a:prstGeom prst="rightArrow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cxnSp>
          <p:nvCxnSpPr>
            <p:cNvPr id="38" name="Conector de Seta Reta 37">
              <a:extLst>
                <a:ext uri="{FF2B5EF4-FFF2-40B4-BE49-F238E27FC236}">
                  <a16:creationId xmlns:a16="http://schemas.microsoft.com/office/drawing/2014/main" id="{C1C79F4E-1C70-1229-04D7-6B22B61687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60358" y="2012905"/>
              <a:ext cx="244287" cy="57452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ector de Seta Reta 39">
              <a:extLst>
                <a:ext uri="{FF2B5EF4-FFF2-40B4-BE49-F238E27FC236}">
                  <a16:creationId xmlns:a16="http://schemas.microsoft.com/office/drawing/2014/main" id="{921496F5-E301-34AC-4BAF-BA384965B86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251" y="1431825"/>
              <a:ext cx="244287" cy="57452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2">
              <a:extLst>
                <a:ext uri="{FF2B5EF4-FFF2-40B4-BE49-F238E27FC236}">
                  <a16:creationId xmlns:a16="http://schemas.microsoft.com/office/drawing/2014/main" id="{B5BCAF66-A1D6-965D-6745-9D3F7583977A}"/>
                </a:ext>
              </a:extLst>
            </p:cNvPr>
            <p:cNvSpPr txBox="1"/>
            <p:nvPr/>
          </p:nvSpPr>
          <p:spPr>
            <a:xfrm>
              <a:off x="3758475" y="3140169"/>
              <a:ext cx="374066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2" name="TextBox 2">
              <a:extLst>
                <a:ext uri="{FF2B5EF4-FFF2-40B4-BE49-F238E27FC236}">
                  <a16:creationId xmlns:a16="http://schemas.microsoft.com/office/drawing/2014/main" id="{7937B3E8-74EB-2C5A-44E8-8AD6D4C8B335}"/>
                </a:ext>
              </a:extLst>
            </p:cNvPr>
            <p:cNvSpPr txBox="1"/>
            <p:nvPr/>
          </p:nvSpPr>
          <p:spPr>
            <a:xfrm>
              <a:off x="3252269" y="3916325"/>
              <a:ext cx="374066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3" name="TextBox 2">
              <a:extLst>
                <a:ext uri="{FF2B5EF4-FFF2-40B4-BE49-F238E27FC236}">
                  <a16:creationId xmlns:a16="http://schemas.microsoft.com/office/drawing/2014/main" id="{02E8A9E9-FA23-A911-EB78-468E04429CD5}"/>
                </a:ext>
              </a:extLst>
            </p:cNvPr>
            <p:cNvSpPr txBox="1"/>
            <p:nvPr/>
          </p:nvSpPr>
          <p:spPr>
            <a:xfrm>
              <a:off x="5808936" y="3140169"/>
              <a:ext cx="374066" cy="369332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44" name="Conector de Seta Reta 43">
              <a:extLst>
                <a:ext uri="{FF2B5EF4-FFF2-40B4-BE49-F238E27FC236}">
                  <a16:creationId xmlns:a16="http://schemas.microsoft.com/office/drawing/2014/main" id="{6C745FE7-F032-8AB2-7A24-A50FCCAF2F0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68904" y="4189486"/>
              <a:ext cx="86125" cy="2105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ector de Seta Reta 45">
              <a:extLst>
                <a:ext uri="{FF2B5EF4-FFF2-40B4-BE49-F238E27FC236}">
                  <a16:creationId xmlns:a16="http://schemas.microsoft.com/office/drawing/2014/main" id="{95EA2651-2462-D59C-0235-81276BB18C9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68324" y="3681253"/>
              <a:ext cx="86125" cy="21051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ector de Seta Reta 46">
              <a:extLst>
                <a:ext uri="{FF2B5EF4-FFF2-40B4-BE49-F238E27FC236}">
                  <a16:creationId xmlns:a16="http://schemas.microsoft.com/office/drawing/2014/main" id="{794CE4B2-DD10-DF00-F9A5-E83FF1C538A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08936" y="3828894"/>
              <a:ext cx="158794" cy="14990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ctor de Seta Reta 48">
              <a:extLst>
                <a:ext uri="{FF2B5EF4-FFF2-40B4-BE49-F238E27FC236}">
                  <a16:creationId xmlns:a16="http://schemas.microsoft.com/office/drawing/2014/main" id="{0D0A6CCC-6335-44C1-BCF5-8E5BA0F1F1A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64227" y="3677293"/>
              <a:ext cx="235871" cy="10065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2">
              <a:extLst>
                <a:ext uri="{FF2B5EF4-FFF2-40B4-BE49-F238E27FC236}">
                  <a16:creationId xmlns:a16="http://schemas.microsoft.com/office/drawing/2014/main" id="{7093A8DC-197F-EE4F-A3FB-87F839AF41EA}"/>
                </a:ext>
              </a:extLst>
            </p:cNvPr>
            <p:cNvSpPr txBox="1"/>
            <p:nvPr/>
          </p:nvSpPr>
          <p:spPr>
            <a:xfrm>
              <a:off x="95299" y="1217427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2">
              <a:extLst>
                <a:ext uri="{FF2B5EF4-FFF2-40B4-BE49-F238E27FC236}">
                  <a16:creationId xmlns:a16="http://schemas.microsoft.com/office/drawing/2014/main" id="{4F378ECB-97F1-A464-ECC1-1F9C0BD08D1E}"/>
                </a:ext>
              </a:extLst>
            </p:cNvPr>
            <p:cNvSpPr txBox="1"/>
            <p:nvPr/>
          </p:nvSpPr>
          <p:spPr>
            <a:xfrm>
              <a:off x="3995225" y="1194458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4" name="TextBox 2">
              <a:extLst>
                <a:ext uri="{FF2B5EF4-FFF2-40B4-BE49-F238E27FC236}">
                  <a16:creationId xmlns:a16="http://schemas.microsoft.com/office/drawing/2014/main" id="{4B25DE54-90F9-B60D-4824-639111F2E2E9}"/>
                </a:ext>
              </a:extLst>
            </p:cNvPr>
            <p:cNvSpPr txBox="1"/>
            <p:nvPr/>
          </p:nvSpPr>
          <p:spPr>
            <a:xfrm>
              <a:off x="5278168" y="1185136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55" name="TextBox 2">
              <a:extLst>
                <a:ext uri="{FF2B5EF4-FFF2-40B4-BE49-F238E27FC236}">
                  <a16:creationId xmlns:a16="http://schemas.microsoft.com/office/drawing/2014/main" id="{75B93E32-C2F9-89AD-666A-377F1B508BC0}"/>
                </a:ext>
              </a:extLst>
            </p:cNvPr>
            <p:cNvSpPr txBox="1"/>
            <p:nvPr/>
          </p:nvSpPr>
          <p:spPr>
            <a:xfrm>
              <a:off x="5308959" y="2730168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56" name="TextBox 2">
              <a:extLst>
                <a:ext uri="{FF2B5EF4-FFF2-40B4-BE49-F238E27FC236}">
                  <a16:creationId xmlns:a16="http://schemas.microsoft.com/office/drawing/2014/main" id="{2182E7B3-87FE-8C9D-F35C-AAEAF80C41A1}"/>
                </a:ext>
              </a:extLst>
            </p:cNvPr>
            <p:cNvSpPr txBox="1"/>
            <p:nvPr/>
          </p:nvSpPr>
          <p:spPr>
            <a:xfrm>
              <a:off x="95299" y="2942032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57" name="TextBox 2">
              <a:extLst>
                <a:ext uri="{FF2B5EF4-FFF2-40B4-BE49-F238E27FC236}">
                  <a16:creationId xmlns:a16="http://schemas.microsoft.com/office/drawing/2014/main" id="{9297E138-13ED-DFA4-2986-0A99FEA31980}"/>
                </a:ext>
              </a:extLst>
            </p:cNvPr>
            <p:cNvSpPr txBox="1"/>
            <p:nvPr/>
          </p:nvSpPr>
          <p:spPr>
            <a:xfrm>
              <a:off x="2535646" y="3514126"/>
              <a:ext cx="250254" cy="307777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31835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Agrupar 6">
            <a:extLst>
              <a:ext uri="{FF2B5EF4-FFF2-40B4-BE49-F238E27FC236}">
                <a16:creationId xmlns:a16="http://schemas.microsoft.com/office/drawing/2014/main" id="{43E6E519-12C1-5463-81A5-E1E61A26F2D4}"/>
              </a:ext>
            </a:extLst>
          </p:cNvPr>
          <p:cNvGrpSpPr/>
          <p:nvPr/>
        </p:nvGrpSpPr>
        <p:grpSpPr>
          <a:xfrm>
            <a:off x="1226820" y="780466"/>
            <a:ext cx="4617720" cy="2458076"/>
            <a:chOff x="1120140" y="2548306"/>
            <a:chExt cx="4617720" cy="2458076"/>
          </a:xfrm>
        </p:grpSpPr>
        <p:sp>
          <p:nvSpPr>
            <p:cNvPr id="4" name="TextBox 2">
              <a:extLst>
                <a:ext uri="{FF2B5EF4-FFF2-40B4-BE49-F238E27FC236}">
                  <a16:creationId xmlns:a16="http://schemas.microsoft.com/office/drawing/2014/main" id="{7226F06E-280F-A9F7-4255-827185CD172C}"/>
                </a:ext>
              </a:extLst>
            </p:cNvPr>
            <p:cNvSpPr txBox="1"/>
            <p:nvPr/>
          </p:nvSpPr>
          <p:spPr>
            <a:xfrm>
              <a:off x="1120140" y="4544717"/>
              <a:ext cx="4617720" cy="461665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just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ig. 4. </a:t>
              </a:r>
              <a:r>
                <a:rPr lang="en-US" sz="1200" i="1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haphiodon</a:t>
              </a:r>
              <a:r>
                <a:rPr lang="en-US" sz="1200" i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vulpinus. </a:t>
              </a:r>
              <a:r>
                <a:rPr lang="en-US" sz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Note that p</a:t>
              </a:r>
              <a:r>
                <a:rPr lang="en-GB" sz="1200" dirty="0" err="1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hotographic</a:t>
              </a:r>
              <a:r>
                <a:rPr lang="en-GB" sz="1200" dirty="0">
                  <a:effectLst/>
                  <a:latin typeface="Arial" panose="020B0604020202020204" pitchFamily="34" charset="0"/>
                  <a:ea typeface="Arial" panose="020B0604020202020204" pitchFamily="34" charset="0"/>
                </a:rPr>
                <a:t> evidence was not obtained for Myxozoa in sample 108.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Imagem 5">
              <a:extLst>
                <a:ext uri="{FF2B5EF4-FFF2-40B4-BE49-F238E27FC236}">
                  <a16:creationId xmlns:a16="http://schemas.microsoft.com/office/drawing/2014/main" id="{99A50404-7272-A47D-E24E-D721E0AC32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20140" y="2548306"/>
              <a:ext cx="4617720" cy="200031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5745333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1</TotalTime>
  <Words>367</Words>
  <Application>Microsoft Office PowerPoint</Application>
  <PresentationFormat>A4 Paper (210x297 mm)</PresentationFormat>
  <Paragraphs>3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Tema do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Edson Adriano</dc:creator>
  <cp:lastModifiedBy>Paul Long</cp:lastModifiedBy>
  <cp:revision>1</cp:revision>
  <dcterms:created xsi:type="dcterms:W3CDTF">2024-03-01T15:54:40Z</dcterms:created>
  <dcterms:modified xsi:type="dcterms:W3CDTF">2024-04-26T08:42:13Z</dcterms:modified>
</cp:coreProperties>
</file>